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slides/slide1.xml" ContentType="application/vnd.openxmlformats-officedocument.presentationml.slide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12"/>
    <p:restoredTop sz="94694"/>
  </p:normalViewPr>
  <p:slideViewPr>
    <p:cSldViewPr snapToGrid="0" snapToObjects="1">
      <p:cViewPr>
        <p:scale>
          <a:sx n="139" d="100"/>
          <a:sy n="139" d="100"/>
        </p:scale>
        <p:origin x="76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974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963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652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538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014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701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217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68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547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768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428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60E49-6DC5-3943-B75D-36A7C3F7881E}" type="datetimeFigureOut">
              <a:rPr lang="en-US" smtClean="0"/>
              <a:t>1/2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E1CC68-BD12-EE43-B083-6EAA077CE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552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aphic 4">
            <a:extLst>
              <a:ext uri="{FF2B5EF4-FFF2-40B4-BE49-F238E27FC236}">
                <a16:creationId xmlns:a16="http://schemas.microsoft.com/office/drawing/2014/main" id="{17FA31FD-1A81-8286-4C94-BEFE60DCDF62}"/>
              </a:ext>
            </a:extLst>
          </p:cNvPr>
          <p:cNvGrpSpPr/>
          <p:nvPr/>
        </p:nvGrpSpPr>
        <p:grpSpPr>
          <a:xfrm>
            <a:off x="1403138" y="450312"/>
            <a:ext cx="4282045" cy="11529391"/>
            <a:chOff x="1403138" y="18416"/>
            <a:chExt cx="4051722" cy="12155166"/>
          </a:xfrm>
        </p:grpSpPr>
        <p:sp>
          <p:nvSpPr>
            <p:cNvPr id="8" name="Freeform 7">
              <a:extLst>
                <a:ext uri="{FF2B5EF4-FFF2-40B4-BE49-F238E27FC236}">
                  <a16:creationId xmlns:a16="http://schemas.microsoft.com/office/drawing/2014/main" id="{4F8E48A0-1D81-6016-36B0-47F72D036647}"/>
                </a:ext>
              </a:extLst>
            </p:cNvPr>
            <p:cNvSpPr/>
            <p:nvPr/>
          </p:nvSpPr>
          <p:spPr>
            <a:xfrm>
              <a:off x="3429000" y="755093"/>
              <a:ext cx="9208" cy="292460"/>
            </a:xfrm>
            <a:custGeom>
              <a:avLst/>
              <a:gdLst>
                <a:gd name="connsiteX0" fmla="*/ 0 w 9208"/>
                <a:gd name="connsiteY0" fmla="*/ 0 h 292460"/>
                <a:gd name="connsiteX1" fmla="*/ 0 w 9208"/>
                <a:gd name="connsiteY1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08" h="292460">
                  <a:moveTo>
                    <a:pt x="0" y="0"/>
                  </a:move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" name="Freeform 8">
              <a:extLst>
                <a:ext uri="{FF2B5EF4-FFF2-40B4-BE49-F238E27FC236}">
                  <a16:creationId xmlns:a16="http://schemas.microsoft.com/office/drawing/2014/main" id="{B64D1BB8-1BFF-BDD4-3EE6-6C0764875604}"/>
                </a:ext>
              </a:extLst>
            </p:cNvPr>
            <p:cNvSpPr/>
            <p:nvPr/>
          </p:nvSpPr>
          <p:spPr>
            <a:xfrm>
              <a:off x="3392166" y="1029137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" name="Freeform 9">
              <a:extLst>
                <a:ext uri="{FF2B5EF4-FFF2-40B4-BE49-F238E27FC236}">
                  <a16:creationId xmlns:a16="http://schemas.microsoft.com/office/drawing/2014/main" id="{95C351FF-FC53-458E-0981-BEA8F646024D}"/>
                </a:ext>
              </a:extLst>
            </p:cNvPr>
            <p:cNvSpPr/>
            <p:nvPr/>
          </p:nvSpPr>
          <p:spPr>
            <a:xfrm>
              <a:off x="2508154" y="18416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FFFFF"/>
            </a:solidFill>
            <a:ln w="36813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F8B5DCB-6E69-6331-A03B-329AB01816DE}"/>
                </a:ext>
              </a:extLst>
            </p:cNvPr>
            <p:cNvSpPr txBox="1"/>
            <p:nvPr/>
          </p:nvSpPr>
          <p:spPr>
            <a:xfrm>
              <a:off x="2831940" y="58022"/>
              <a:ext cx="1184910" cy="661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FULL COHORT</a:t>
              </a:r>
              <a:endParaRPr lang="en-US" sz="1160" b="1" dirty="0">
                <a:solidFill>
                  <a:srgbClr val="000000"/>
                </a:solidFill>
                <a:latin typeface="Helvetica"/>
                <a:sym typeface="Helvetica"/>
                <a:rtl val="0"/>
              </a:endParaRPr>
            </a:p>
            <a:p>
              <a:pPr algn="ctr"/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=5572</a:t>
              </a:r>
            </a:p>
            <a:p>
              <a:pPr algn="ctr"/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scans=20355</a:t>
              </a:r>
              <a:endParaRPr lang="en-US" sz="1160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12" name="Freeform 11">
              <a:extLst>
                <a:ext uri="{FF2B5EF4-FFF2-40B4-BE49-F238E27FC236}">
                  <a16:creationId xmlns:a16="http://schemas.microsoft.com/office/drawing/2014/main" id="{AAAC28E6-7B3C-5674-981A-2DC82009E2C8}"/>
                </a:ext>
              </a:extLst>
            </p:cNvPr>
            <p:cNvSpPr/>
            <p:nvPr/>
          </p:nvSpPr>
          <p:spPr>
            <a:xfrm>
              <a:off x="2323984" y="2596785"/>
              <a:ext cx="1105015" cy="292460"/>
            </a:xfrm>
            <a:custGeom>
              <a:avLst/>
              <a:gdLst>
                <a:gd name="connsiteX0" fmla="*/ 0 w 1105015"/>
                <a:gd name="connsiteY0" fmla="*/ 0 h 292460"/>
                <a:gd name="connsiteX1" fmla="*/ 0 w 1105015"/>
                <a:gd name="connsiteY1" fmla="*/ 184169 h 292460"/>
                <a:gd name="connsiteX2" fmla="*/ 1105015 w 1105015"/>
                <a:gd name="connsiteY2" fmla="*/ 184169 h 292460"/>
                <a:gd name="connsiteX3" fmla="*/ 1105015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0" y="0"/>
                  </a:moveTo>
                  <a:lnTo>
                    <a:pt x="0" y="184169"/>
                  </a:lnTo>
                  <a:lnTo>
                    <a:pt x="1105015" y="184169"/>
                  </a:lnTo>
                  <a:lnTo>
                    <a:pt x="1105015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3" name="Freeform 12">
              <a:extLst>
                <a:ext uri="{FF2B5EF4-FFF2-40B4-BE49-F238E27FC236}">
                  <a16:creationId xmlns:a16="http://schemas.microsoft.com/office/drawing/2014/main" id="{BC68D863-91EE-58FB-F67C-9BF7676007C0}"/>
                </a:ext>
              </a:extLst>
            </p:cNvPr>
            <p:cNvSpPr/>
            <p:nvPr/>
          </p:nvSpPr>
          <p:spPr>
            <a:xfrm>
              <a:off x="3392166" y="2870829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4" name="Freeform 13">
              <a:extLst>
                <a:ext uri="{FF2B5EF4-FFF2-40B4-BE49-F238E27FC236}">
                  <a16:creationId xmlns:a16="http://schemas.microsoft.com/office/drawing/2014/main" id="{F7F0B87F-F067-CFA3-AFE0-864256ED6D16}"/>
                </a:ext>
              </a:extLst>
            </p:cNvPr>
            <p:cNvSpPr/>
            <p:nvPr/>
          </p:nvSpPr>
          <p:spPr>
            <a:xfrm>
              <a:off x="1403138" y="1860108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FFFFF"/>
            </a:solidFill>
            <a:ln w="36813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4A68EDC-DF0C-CF5A-F2ED-92C21EAE46C5}"/>
                </a:ext>
              </a:extLst>
            </p:cNvPr>
            <p:cNvSpPr txBox="1"/>
            <p:nvPr/>
          </p:nvSpPr>
          <p:spPr>
            <a:xfrm>
              <a:off x="1841185" y="1903674"/>
              <a:ext cx="939190" cy="661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INCLUDE</a:t>
              </a:r>
              <a:endParaRPr lang="en-US" sz="1160" b="1" dirty="0">
                <a:solidFill>
                  <a:srgbClr val="000000"/>
                </a:solidFill>
                <a:latin typeface="Helvetica"/>
                <a:sym typeface="Helvetica"/>
                <a:rtl val="0"/>
              </a:endParaRPr>
            </a:p>
            <a:p>
              <a:pPr algn="ctr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=1145</a:t>
              </a:r>
            </a:p>
            <a:p>
              <a:pPr algn="ctr"/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scans=5312</a:t>
              </a:r>
              <a:endParaRPr lang="en-US" sz="1160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16" name="Freeform 15">
              <a:extLst>
                <a:ext uri="{FF2B5EF4-FFF2-40B4-BE49-F238E27FC236}">
                  <a16:creationId xmlns:a16="http://schemas.microsoft.com/office/drawing/2014/main" id="{63BADBA7-22CA-0E55-71C2-D71A72ECA200}"/>
                </a:ext>
              </a:extLst>
            </p:cNvPr>
            <p:cNvSpPr/>
            <p:nvPr/>
          </p:nvSpPr>
          <p:spPr>
            <a:xfrm>
              <a:off x="3613169" y="1860108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5F5F5"/>
            </a:solidFill>
            <a:ln w="18406" cap="flat">
              <a:solidFill>
                <a:srgbClr val="666666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78B0681-04B8-191E-CC7B-5D8A1135848E}"/>
                </a:ext>
              </a:extLst>
            </p:cNvPr>
            <p:cNvSpPr txBox="1"/>
            <p:nvPr/>
          </p:nvSpPr>
          <p:spPr>
            <a:xfrm>
              <a:off x="4028194" y="1894379"/>
              <a:ext cx="1018063" cy="661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333333"/>
                  </a:solidFill>
                  <a:latin typeface="Helvetica"/>
                  <a:sym typeface="Helvetica"/>
                  <a:rtl val="0"/>
                </a:rPr>
                <a:t>EXCLUDE</a:t>
              </a:r>
              <a:endParaRPr lang="en-US" sz="1160" b="1" dirty="0">
                <a:solidFill>
                  <a:srgbClr val="333333"/>
                </a:solidFill>
                <a:latin typeface="Helvetica"/>
                <a:sym typeface="Helvetica"/>
                <a:rtl val="0"/>
              </a:endParaRPr>
            </a:p>
            <a:p>
              <a:pPr algn="ctr"/>
              <a:r>
                <a:rPr lang="en-US" sz="1160" spc="0" baseline="0" dirty="0">
                  <a:solidFill>
                    <a:srgbClr val="333333"/>
                  </a:solidFill>
                  <a:latin typeface="Helvetica"/>
                  <a:sym typeface="Helvetica"/>
                  <a:rtl val="0"/>
                </a:rPr>
                <a:t>n=4427</a:t>
              </a:r>
            </a:p>
            <a:p>
              <a:pPr algn="ctr"/>
              <a:r>
                <a:rPr lang="en-US" sz="1160" dirty="0">
                  <a:solidFill>
                    <a:srgbClr val="333333"/>
                  </a:solidFill>
                  <a:latin typeface="Helvetica"/>
                  <a:sym typeface="Helvetica"/>
                  <a:rtl val="0"/>
                </a:rPr>
                <a:t>scans=15043</a:t>
              </a:r>
              <a:endParaRPr lang="en-US" sz="1160" spc="0" baseline="0" dirty="0">
                <a:solidFill>
                  <a:srgbClr val="333333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18" name="Freeform 17">
              <a:extLst>
                <a:ext uri="{FF2B5EF4-FFF2-40B4-BE49-F238E27FC236}">
                  <a16:creationId xmlns:a16="http://schemas.microsoft.com/office/drawing/2014/main" id="{302B63C5-19F5-1D13-B048-22E633EB8457}"/>
                </a:ext>
              </a:extLst>
            </p:cNvPr>
            <p:cNvSpPr/>
            <p:nvPr/>
          </p:nvSpPr>
          <p:spPr>
            <a:xfrm>
              <a:off x="2323984" y="1491770"/>
              <a:ext cx="1105015" cy="292460"/>
            </a:xfrm>
            <a:custGeom>
              <a:avLst/>
              <a:gdLst>
                <a:gd name="connsiteX0" fmla="*/ 1105015 w 1105015"/>
                <a:gd name="connsiteY0" fmla="*/ 0 h 292460"/>
                <a:gd name="connsiteX1" fmla="*/ 1105015 w 1105015"/>
                <a:gd name="connsiteY1" fmla="*/ 184169 h 292460"/>
                <a:gd name="connsiteX2" fmla="*/ 0 w 1105015"/>
                <a:gd name="connsiteY2" fmla="*/ 184169 h 292460"/>
                <a:gd name="connsiteX3" fmla="*/ 0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1105015" y="0"/>
                  </a:moveTo>
                  <a:lnTo>
                    <a:pt x="1105015" y="184169"/>
                  </a:lnTo>
                  <a:lnTo>
                    <a:pt x="0" y="184169"/>
                  </a:ln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id="{15C28AD6-6E1F-379A-FD16-E902CE588775}"/>
                </a:ext>
              </a:extLst>
            </p:cNvPr>
            <p:cNvSpPr/>
            <p:nvPr/>
          </p:nvSpPr>
          <p:spPr>
            <a:xfrm>
              <a:off x="2287151" y="1765814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A7AFF84-B055-D0A7-428D-3268A401D703}"/>
                </a:ext>
              </a:extLst>
            </p:cNvPr>
            <p:cNvSpPr txBox="1"/>
            <p:nvPr/>
          </p:nvSpPr>
          <p:spPr>
            <a:xfrm>
              <a:off x="2642321" y="1552906"/>
              <a:ext cx="477550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YES</a:t>
              </a:r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6C3FC601-05B1-ED84-6746-B4DD9A3C24F2}"/>
                </a:ext>
              </a:extLst>
            </p:cNvPr>
            <p:cNvSpPr/>
            <p:nvPr/>
          </p:nvSpPr>
          <p:spPr>
            <a:xfrm>
              <a:off x="3429000" y="1491770"/>
              <a:ext cx="1105015" cy="292460"/>
            </a:xfrm>
            <a:custGeom>
              <a:avLst/>
              <a:gdLst>
                <a:gd name="connsiteX0" fmla="*/ 0 w 1105015"/>
                <a:gd name="connsiteY0" fmla="*/ 0 h 292460"/>
                <a:gd name="connsiteX1" fmla="*/ 0 w 1105015"/>
                <a:gd name="connsiteY1" fmla="*/ 184169 h 292460"/>
                <a:gd name="connsiteX2" fmla="*/ 1105015 w 1105015"/>
                <a:gd name="connsiteY2" fmla="*/ 184169 h 292460"/>
                <a:gd name="connsiteX3" fmla="*/ 1105015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0" y="0"/>
                  </a:moveTo>
                  <a:lnTo>
                    <a:pt x="0" y="184169"/>
                  </a:lnTo>
                  <a:lnTo>
                    <a:pt x="1105015" y="184169"/>
                  </a:lnTo>
                  <a:lnTo>
                    <a:pt x="1105015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278B09C2-CB7E-ED62-FCC2-47B216CB6D64}"/>
                </a:ext>
              </a:extLst>
            </p:cNvPr>
            <p:cNvSpPr/>
            <p:nvPr/>
          </p:nvSpPr>
          <p:spPr>
            <a:xfrm>
              <a:off x="4497181" y="1765814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E62E495-55DF-514F-3DCF-CA62CECA2F77}"/>
                </a:ext>
              </a:extLst>
            </p:cNvPr>
            <p:cNvSpPr txBox="1"/>
            <p:nvPr/>
          </p:nvSpPr>
          <p:spPr>
            <a:xfrm>
              <a:off x="3793378" y="1552906"/>
              <a:ext cx="403883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O</a:t>
              </a:r>
            </a:p>
          </p:txBody>
        </p:sp>
        <p:sp>
          <p:nvSpPr>
            <p:cNvPr id="24" name="Freeform 23">
              <a:extLst>
                <a:ext uri="{FF2B5EF4-FFF2-40B4-BE49-F238E27FC236}">
                  <a16:creationId xmlns:a16="http://schemas.microsoft.com/office/drawing/2014/main" id="{6CD2E044-486B-E7C1-C13F-314C543893B0}"/>
                </a:ext>
              </a:extLst>
            </p:cNvPr>
            <p:cNvSpPr/>
            <p:nvPr/>
          </p:nvSpPr>
          <p:spPr>
            <a:xfrm>
              <a:off x="1403138" y="1123432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id="{363F4BAF-FDEA-3565-E362-1FA7454ACFD4}"/>
                </a:ext>
              </a:extLst>
            </p:cNvPr>
            <p:cNvSpPr/>
            <p:nvPr/>
          </p:nvSpPr>
          <p:spPr>
            <a:xfrm>
              <a:off x="1403138" y="1123432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6" name="Freeform 25">
              <a:extLst>
                <a:ext uri="{FF2B5EF4-FFF2-40B4-BE49-F238E27FC236}">
                  <a16:creationId xmlns:a16="http://schemas.microsoft.com/office/drawing/2014/main" id="{F3956686-5B3F-276E-5421-A21934722DC0}"/>
                </a:ext>
              </a:extLst>
            </p:cNvPr>
            <p:cNvSpPr/>
            <p:nvPr/>
          </p:nvSpPr>
          <p:spPr>
            <a:xfrm>
              <a:off x="1403138" y="1123432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moveTo>
                    <a:pt x="4051722" y="368338"/>
                  </a:moveTo>
                  <a:lnTo>
                    <a:pt x="0" y="368338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EAD3740-1E61-1334-9F60-9E9FCD78FCB4}"/>
                </a:ext>
              </a:extLst>
            </p:cNvPr>
            <p:cNvSpPr txBox="1"/>
            <p:nvPr/>
          </p:nvSpPr>
          <p:spPr>
            <a:xfrm>
              <a:off x="2596279" y="1164184"/>
              <a:ext cx="1656233" cy="238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Cerclage in pregnancy</a:t>
              </a:r>
            </a:p>
          </p:txBody>
        </p:sp>
        <p:sp>
          <p:nvSpPr>
            <p:cNvPr id="28" name="Freeform 27">
              <a:extLst>
                <a:ext uri="{FF2B5EF4-FFF2-40B4-BE49-F238E27FC236}">
                  <a16:creationId xmlns:a16="http://schemas.microsoft.com/office/drawing/2014/main" id="{303C71AB-A4D9-9853-ED82-0F9041118A23}"/>
                </a:ext>
              </a:extLst>
            </p:cNvPr>
            <p:cNvSpPr/>
            <p:nvPr/>
          </p:nvSpPr>
          <p:spPr>
            <a:xfrm>
              <a:off x="2323984" y="3333462"/>
              <a:ext cx="1105015" cy="292460"/>
            </a:xfrm>
            <a:custGeom>
              <a:avLst/>
              <a:gdLst>
                <a:gd name="connsiteX0" fmla="*/ 1105015 w 1105015"/>
                <a:gd name="connsiteY0" fmla="*/ 0 h 292460"/>
                <a:gd name="connsiteX1" fmla="*/ 1105015 w 1105015"/>
                <a:gd name="connsiteY1" fmla="*/ 184169 h 292460"/>
                <a:gd name="connsiteX2" fmla="*/ 0 w 1105015"/>
                <a:gd name="connsiteY2" fmla="*/ 184169 h 292460"/>
                <a:gd name="connsiteX3" fmla="*/ 0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1105015" y="0"/>
                  </a:moveTo>
                  <a:lnTo>
                    <a:pt x="1105015" y="184169"/>
                  </a:lnTo>
                  <a:lnTo>
                    <a:pt x="0" y="184169"/>
                  </a:ln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29" name="Freeform 28">
              <a:extLst>
                <a:ext uri="{FF2B5EF4-FFF2-40B4-BE49-F238E27FC236}">
                  <a16:creationId xmlns:a16="http://schemas.microsoft.com/office/drawing/2014/main" id="{33388637-A5A5-D5F8-C219-CD816737B58F}"/>
                </a:ext>
              </a:extLst>
            </p:cNvPr>
            <p:cNvSpPr/>
            <p:nvPr/>
          </p:nvSpPr>
          <p:spPr>
            <a:xfrm>
              <a:off x="2287151" y="3607506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D34F871-6A91-4654-AFBB-1F0E7375965F}"/>
                </a:ext>
              </a:extLst>
            </p:cNvPr>
            <p:cNvSpPr txBox="1"/>
            <p:nvPr/>
          </p:nvSpPr>
          <p:spPr>
            <a:xfrm>
              <a:off x="2651529" y="3394257"/>
              <a:ext cx="477550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YES</a:t>
              </a:r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id="{F3073388-1B96-7938-8D0A-FC78DBEB68DB}"/>
                </a:ext>
              </a:extLst>
            </p:cNvPr>
            <p:cNvSpPr/>
            <p:nvPr/>
          </p:nvSpPr>
          <p:spPr>
            <a:xfrm>
              <a:off x="3429000" y="3333462"/>
              <a:ext cx="1105015" cy="292460"/>
            </a:xfrm>
            <a:custGeom>
              <a:avLst/>
              <a:gdLst>
                <a:gd name="connsiteX0" fmla="*/ 0 w 1105015"/>
                <a:gd name="connsiteY0" fmla="*/ 0 h 292460"/>
                <a:gd name="connsiteX1" fmla="*/ 0 w 1105015"/>
                <a:gd name="connsiteY1" fmla="*/ 184169 h 292460"/>
                <a:gd name="connsiteX2" fmla="*/ 1105015 w 1105015"/>
                <a:gd name="connsiteY2" fmla="*/ 184169 h 292460"/>
                <a:gd name="connsiteX3" fmla="*/ 1105015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0" y="0"/>
                  </a:moveTo>
                  <a:lnTo>
                    <a:pt x="0" y="184169"/>
                  </a:lnTo>
                  <a:lnTo>
                    <a:pt x="1105015" y="184169"/>
                  </a:lnTo>
                  <a:lnTo>
                    <a:pt x="1105015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2" name="Freeform 31">
              <a:extLst>
                <a:ext uri="{FF2B5EF4-FFF2-40B4-BE49-F238E27FC236}">
                  <a16:creationId xmlns:a16="http://schemas.microsoft.com/office/drawing/2014/main" id="{C3888B77-B395-D670-AA8B-CDB2D3BCF819}"/>
                </a:ext>
              </a:extLst>
            </p:cNvPr>
            <p:cNvSpPr/>
            <p:nvPr/>
          </p:nvSpPr>
          <p:spPr>
            <a:xfrm>
              <a:off x="4497181" y="3607506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7F1DF1A-E571-592F-D1AF-95945818975D}"/>
                </a:ext>
              </a:extLst>
            </p:cNvPr>
            <p:cNvSpPr txBox="1"/>
            <p:nvPr/>
          </p:nvSpPr>
          <p:spPr>
            <a:xfrm>
              <a:off x="3747336" y="3403466"/>
              <a:ext cx="403883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O</a:t>
              </a:r>
            </a:p>
          </p:txBody>
        </p:sp>
        <p:sp>
          <p:nvSpPr>
            <p:cNvPr id="34" name="Freeform 33">
              <a:extLst>
                <a:ext uri="{FF2B5EF4-FFF2-40B4-BE49-F238E27FC236}">
                  <a16:creationId xmlns:a16="http://schemas.microsoft.com/office/drawing/2014/main" id="{612E7664-49B0-BB5E-9977-81BD083EA72E}"/>
                </a:ext>
              </a:extLst>
            </p:cNvPr>
            <p:cNvSpPr/>
            <p:nvPr/>
          </p:nvSpPr>
          <p:spPr>
            <a:xfrm>
              <a:off x="1403138" y="2965123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C4000504-6736-6B4A-BA32-E85615E3CD41}"/>
                </a:ext>
              </a:extLst>
            </p:cNvPr>
            <p:cNvSpPr/>
            <p:nvPr/>
          </p:nvSpPr>
          <p:spPr>
            <a:xfrm>
              <a:off x="1403138" y="2965123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141EA2EC-2A11-2ACD-C60E-CAD2805FB276}"/>
                </a:ext>
              </a:extLst>
            </p:cNvPr>
            <p:cNvSpPr/>
            <p:nvPr/>
          </p:nvSpPr>
          <p:spPr>
            <a:xfrm>
              <a:off x="1403138" y="2965123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moveTo>
                    <a:pt x="4051722" y="368338"/>
                  </a:moveTo>
                  <a:lnTo>
                    <a:pt x="0" y="368338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87A3E7E-7739-BAC6-A2D8-22232890CE80}"/>
                </a:ext>
              </a:extLst>
            </p:cNvPr>
            <p:cNvSpPr txBox="1"/>
            <p:nvPr/>
          </p:nvSpPr>
          <p:spPr>
            <a:xfrm>
              <a:off x="2448943" y="3005876"/>
              <a:ext cx="1950904" cy="238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Progesterone in pregnancy</a:t>
              </a:r>
            </a:p>
          </p:txBody>
        </p:sp>
        <p:sp>
          <p:nvSpPr>
            <p:cNvPr id="38" name="Freeform 37">
              <a:extLst>
                <a:ext uri="{FF2B5EF4-FFF2-40B4-BE49-F238E27FC236}">
                  <a16:creationId xmlns:a16="http://schemas.microsoft.com/office/drawing/2014/main" id="{653A1FA9-C150-C9E3-6689-EF1D10E04562}"/>
                </a:ext>
              </a:extLst>
            </p:cNvPr>
            <p:cNvSpPr/>
            <p:nvPr/>
          </p:nvSpPr>
          <p:spPr>
            <a:xfrm>
              <a:off x="3429000" y="4438477"/>
              <a:ext cx="1105015" cy="292460"/>
            </a:xfrm>
            <a:custGeom>
              <a:avLst/>
              <a:gdLst>
                <a:gd name="connsiteX0" fmla="*/ 1105015 w 1105015"/>
                <a:gd name="connsiteY0" fmla="*/ 0 h 292460"/>
                <a:gd name="connsiteX1" fmla="*/ 1105015 w 1105015"/>
                <a:gd name="connsiteY1" fmla="*/ 184169 h 292460"/>
                <a:gd name="connsiteX2" fmla="*/ 0 w 1105015"/>
                <a:gd name="connsiteY2" fmla="*/ 184169 h 292460"/>
                <a:gd name="connsiteX3" fmla="*/ 0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1105015" y="0"/>
                  </a:moveTo>
                  <a:lnTo>
                    <a:pt x="1105015" y="184169"/>
                  </a:lnTo>
                  <a:lnTo>
                    <a:pt x="0" y="184169"/>
                  </a:ln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C78816D6-28CC-9210-334F-BC4CA0C65E5B}"/>
                </a:ext>
              </a:extLst>
            </p:cNvPr>
            <p:cNvSpPr/>
            <p:nvPr/>
          </p:nvSpPr>
          <p:spPr>
            <a:xfrm>
              <a:off x="3392166" y="4712521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0" name="Freeform 39">
              <a:extLst>
                <a:ext uri="{FF2B5EF4-FFF2-40B4-BE49-F238E27FC236}">
                  <a16:creationId xmlns:a16="http://schemas.microsoft.com/office/drawing/2014/main" id="{BDBBB675-95B9-671E-130C-1BF95C63C67E}"/>
                </a:ext>
              </a:extLst>
            </p:cNvPr>
            <p:cNvSpPr/>
            <p:nvPr/>
          </p:nvSpPr>
          <p:spPr>
            <a:xfrm>
              <a:off x="3613169" y="3701800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FFFFF"/>
            </a:solidFill>
            <a:ln w="36813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C2B0CCB-591E-9701-243E-D53AF7072081}"/>
                </a:ext>
              </a:extLst>
            </p:cNvPr>
            <p:cNvSpPr txBox="1"/>
            <p:nvPr/>
          </p:nvSpPr>
          <p:spPr>
            <a:xfrm>
              <a:off x="4073673" y="3733593"/>
              <a:ext cx="939190" cy="661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INCLUDE</a:t>
              </a:r>
            </a:p>
            <a:p>
              <a:pPr algn="ctr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=621</a:t>
              </a:r>
            </a:p>
            <a:p>
              <a:pPr algn="ctr"/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scans=2797</a:t>
              </a:r>
              <a:endParaRPr lang="en-US" sz="1160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42" name="Freeform 41">
              <a:extLst>
                <a:ext uri="{FF2B5EF4-FFF2-40B4-BE49-F238E27FC236}">
                  <a16:creationId xmlns:a16="http://schemas.microsoft.com/office/drawing/2014/main" id="{08AB4EA0-E50B-BF13-742A-A2CC8400A3EE}"/>
                </a:ext>
              </a:extLst>
            </p:cNvPr>
            <p:cNvSpPr/>
            <p:nvPr/>
          </p:nvSpPr>
          <p:spPr>
            <a:xfrm>
              <a:off x="1403138" y="3701800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5F5F5"/>
            </a:solidFill>
            <a:ln w="18406" cap="flat">
              <a:solidFill>
                <a:srgbClr val="666666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FC31C89-E7EF-4890-A490-F7F60EC6F495}"/>
                </a:ext>
              </a:extLst>
            </p:cNvPr>
            <p:cNvSpPr txBox="1"/>
            <p:nvPr/>
          </p:nvSpPr>
          <p:spPr>
            <a:xfrm>
              <a:off x="1795178" y="3741266"/>
              <a:ext cx="939190" cy="661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333333"/>
                  </a:solidFill>
                  <a:latin typeface="Helvetica"/>
                  <a:sym typeface="Helvetica"/>
                  <a:rtl val="0"/>
                </a:rPr>
                <a:t>EXCLUDE</a:t>
              </a:r>
              <a:endParaRPr lang="en-US" sz="1160" b="1" dirty="0">
                <a:solidFill>
                  <a:srgbClr val="333333"/>
                </a:solidFill>
                <a:latin typeface="Helvetica"/>
                <a:sym typeface="Helvetica"/>
                <a:rtl val="0"/>
              </a:endParaRPr>
            </a:p>
            <a:p>
              <a:pPr algn="ctr"/>
              <a:r>
                <a:rPr lang="en-US" sz="1160" spc="0" baseline="0" dirty="0">
                  <a:solidFill>
                    <a:srgbClr val="333333"/>
                  </a:solidFill>
                  <a:latin typeface="Helvetica"/>
                  <a:sym typeface="Helvetica"/>
                  <a:rtl val="0"/>
                </a:rPr>
                <a:t>n=524</a:t>
              </a:r>
            </a:p>
            <a:p>
              <a:pPr algn="ctr"/>
              <a:r>
                <a:rPr lang="en-US" sz="1160" dirty="0">
                  <a:solidFill>
                    <a:srgbClr val="333333"/>
                  </a:solidFill>
                  <a:latin typeface="Helvetica"/>
                  <a:sym typeface="Helvetica"/>
                  <a:rtl val="0"/>
                </a:rPr>
                <a:t>scans=2515</a:t>
              </a:r>
              <a:endParaRPr lang="en-US" sz="1160" spc="0" baseline="0" dirty="0">
                <a:solidFill>
                  <a:srgbClr val="333333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44" name="Freeform 43">
              <a:extLst>
                <a:ext uri="{FF2B5EF4-FFF2-40B4-BE49-F238E27FC236}">
                  <a16:creationId xmlns:a16="http://schemas.microsoft.com/office/drawing/2014/main" id="{01071749-B743-8554-72B6-69C72C57FB57}"/>
                </a:ext>
              </a:extLst>
            </p:cNvPr>
            <p:cNvSpPr/>
            <p:nvPr/>
          </p:nvSpPr>
          <p:spPr>
            <a:xfrm>
              <a:off x="2323984" y="5175154"/>
              <a:ext cx="1105015" cy="292460"/>
            </a:xfrm>
            <a:custGeom>
              <a:avLst/>
              <a:gdLst>
                <a:gd name="connsiteX0" fmla="*/ 1105015 w 1105015"/>
                <a:gd name="connsiteY0" fmla="*/ 0 h 292460"/>
                <a:gd name="connsiteX1" fmla="*/ 1105015 w 1105015"/>
                <a:gd name="connsiteY1" fmla="*/ 184169 h 292460"/>
                <a:gd name="connsiteX2" fmla="*/ 0 w 1105015"/>
                <a:gd name="connsiteY2" fmla="*/ 184169 h 292460"/>
                <a:gd name="connsiteX3" fmla="*/ 0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1105015" y="0"/>
                  </a:moveTo>
                  <a:lnTo>
                    <a:pt x="1105015" y="184169"/>
                  </a:lnTo>
                  <a:lnTo>
                    <a:pt x="0" y="184169"/>
                  </a:ln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FB74DF03-1D12-5CFB-E993-2A7AD456CFCD}"/>
                </a:ext>
              </a:extLst>
            </p:cNvPr>
            <p:cNvSpPr/>
            <p:nvPr/>
          </p:nvSpPr>
          <p:spPr>
            <a:xfrm>
              <a:off x="2287151" y="5449197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0FDC69AD-C6A4-EC58-ABCC-086492266ABF}"/>
                </a:ext>
              </a:extLst>
            </p:cNvPr>
            <p:cNvSpPr txBox="1"/>
            <p:nvPr/>
          </p:nvSpPr>
          <p:spPr>
            <a:xfrm>
              <a:off x="2651529" y="5236288"/>
              <a:ext cx="477550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YES</a:t>
              </a:r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759E9291-34D3-4E61-EA31-0C8B9E39EB3E}"/>
                </a:ext>
              </a:extLst>
            </p:cNvPr>
            <p:cNvSpPr/>
            <p:nvPr/>
          </p:nvSpPr>
          <p:spPr>
            <a:xfrm>
              <a:off x="3429000" y="5175154"/>
              <a:ext cx="1105015" cy="292460"/>
            </a:xfrm>
            <a:custGeom>
              <a:avLst/>
              <a:gdLst>
                <a:gd name="connsiteX0" fmla="*/ 0 w 1105015"/>
                <a:gd name="connsiteY0" fmla="*/ 0 h 292460"/>
                <a:gd name="connsiteX1" fmla="*/ 0 w 1105015"/>
                <a:gd name="connsiteY1" fmla="*/ 184169 h 292460"/>
                <a:gd name="connsiteX2" fmla="*/ 1105015 w 1105015"/>
                <a:gd name="connsiteY2" fmla="*/ 184169 h 292460"/>
                <a:gd name="connsiteX3" fmla="*/ 1105015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0" y="0"/>
                  </a:moveTo>
                  <a:lnTo>
                    <a:pt x="0" y="184169"/>
                  </a:lnTo>
                  <a:lnTo>
                    <a:pt x="1105015" y="184169"/>
                  </a:lnTo>
                  <a:lnTo>
                    <a:pt x="1105015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B598E1C7-E11D-9F19-3817-35A2E3B0F449}"/>
                </a:ext>
              </a:extLst>
            </p:cNvPr>
            <p:cNvSpPr/>
            <p:nvPr/>
          </p:nvSpPr>
          <p:spPr>
            <a:xfrm>
              <a:off x="4497181" y="5449197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A4FA098-07BE-AD8A-E0B3-224503D47752}"/>
                </a:ext>
              </a:extLst>
            </p:cNvPr>
            <p:cNvSpPr txBox="1"/>
            <p:nvPr/>
          </p:nvSpPr>
          <p:spPr>
            <a:xfrm>
              <a:off x="3784170" y="5245496"/>
              <a:ext cx="403883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O</a:t>
              </a:r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FC670302-DDBC-A5C7-9416-54FDEFCCEBD9}"/>
                </a:ext>
              </a:extLst>
            </p:cNvPr>
            <p:cNvSpPr/>
            <p:nvPr/>
          </p:nvSpPr>
          <p:spPr>
            <a:xfrm>
              <a:off x="1403138" y="4806815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1" name="Freeform 50">
              <a:extLst>
                <a:ext uri="{FF2B5EF4-FFF2-40B4-BE49-F238E27FC236}">
                  <a16:creationId xmlns:a16="http://schemas.microsoft.com/office/drawing/2014/main" id="{23B8A508-0C16-9071-53F6-D95BBDA42AFD}"/>
                </a:ext>
              </a:extLst>
            </p:cNvPr>
            <p:cNvSpPr/>
            <p:nvPr/>
          </p:nvSpPr>
          <p:spPr>
            <a:xfrm>
              <a:off x="1403138" y="4806815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id="{76045031-DF47-94DF-7837-D6BE4DD64BB1}"/>
                </a:ext>
              </a:extLst>
            </p:cNvPr>
            <p:cNvSpPr/>
            <p:nvPr/>
          </p:nvSpPr>
          <p:spPr>
            <a:xfrm>
              <a:off x="1403138" y="4806815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moveTo>
                    <a:pt x="4051722" y="368338"/>
                  </a:moveTo>
                  <a:lnTo>
                    <a:pt x="0" y="368338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913C3F2C-7983-CE88-1FD7-665D88BCFA5B}"/>
                </a:ext>
              </a:extLst>
            </p:cNvPr>
            <p:cNvSpPr txBox="1"/>
            <p:nvPr/>
          </p:nvSpPr>
          <p:spPr>
            <a:xfrm>
              <a:off x="2080605" y="4857112"/>
              <a:ext cx="2687580" cy="238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Matched pre- and post-cerclage scans</a:t>
              </a:r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id="{B48A7A55-C83E-CFE2-6FD7-1CBE2C2DB2CA}"/>
                </a:ext>
              </a:extLst>
            </p:cNvPr>
            <p:cNvSpPr/>
            <p:nvPr/>
          </p:nvSpPr>
          <p:spPr>
            <a:xfrm>
              <a:off x="2323984" y="6280169"/>
              <a:ext cx="1105015" cy="292460"/>
            </a:xfrm>
            <a:custGeom>
              <a:avLst/>
              <a:gdLst>
                <a:gd name="connsiteX0" fmla="*/ 0 w 1105015"/>
                <a:gd name="connsiteY0" fmla="*/ 0 h 292460"/>
                <a:gd name="connsiteX1" fmla="*/ 0 w 1105015"/>
                <a:gd name="connsiteY1" fmla="*/ 184169 h 292460"/>
                <a:gd name="connsiteX2" fmla="*/ 1105015 w 1105015"/>
                <a:gd name="connsiteY2" fmla="*/ 184169 h 292460"/>
                <a:gd name="connsiteX3" fmla="*/ 1105015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0" y="0"/>
                  </a:moveTo>
                  <a:lnTo>
                    <a:pt x="0" y="184169"/>
                  </a:lnTo>
                  <a:lnTo>
                    <a:pt x="1105015" y="184169"/>
                  </a:lnTo>
                  <a:lnTo>
                    <a:pt x="1105015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0C958F27-3BCF-A654-0101-5C3D7CB694DF}"/>
                </a:ext>
              </a:extLst>
            </p:cNvPr>
            <p:cNvSpPr/>
            <p:nvPr/>
          </p:nvSpPr>
          <p:spPr>
            <a:xfrm>
              <a:off x="3392166" y="6554213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id="{2D10A68D-C5F7-E1B9-3C68-F8DD8E0EA2E8}"/>
                </a:ext>
              </a:extLst>
            </p:cNvPr>
            <p:cNvSpPr/>
            <p:nvPr/>
          </p:nvSpPr>
          <p:spPr>
            <a:xfrm>
              <a:off x="1403138" y="5543492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FFFFF"/>
            </a:solidFill>
            <a:ln w="36813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F3E4EDC8-C87F-0882-72F7-A949D2C962B0}"/>
                </a:ext>
              </a:extLst>
            </p:cNvPr>
            <p:cNvSpPr txBox="1"/>
            <p:nvPr/>
          </p:nvSpPr>
          <p:spPr>
            <a:xfrm>
              <a:off x="1913989" y="5676276"/>
              <a:ext cx="793579" cy="4737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INCLUDE</a:t>
              </a:r>
            </a:p>
            <a:p>
              <a:pPr algn="ctr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=432</a:t>
              </a:r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id="{A64F0DD2-CBFE-A857-E6AD-E6D5F58D421F}"/>
                </a:ext>
              </a:extLst>
            </p:cNvPr>
            <p:cNvSpPr/>
            <p:nvPr/>
          </p:nvSpPr>
          <p:spPr>
            <a:xfrm>
              <a:off x="3613169" y="5543492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5F5F5"/>
            </a:solidFill>
            <a:ln w="18406" cap="flat">
              <a:solidFill>
                <a:srgbClr val="666666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1611AD9-D4B4-37DD-F2CF-96E3BA00C696}"/>
                </a:ext>
              </a:extLst>
            </p:cNvPr>
            <p:cNvSpPr txBox="1"/>
            <p:nvPr/>
          </p:nvSpPr>
          <p:spPr>
            <a:xfrm>
              <a:off x="4122922" y="5676276"/>
              <a:ext cx="840600" cy="4737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333333"/>
                  </a:solidFill>
                  <a:latin typeface="Helvetica"/>
                  <a:sym typeface="Helvetica"/>
                  <a:rtl val="0"/>
                </a:rPr>
                <a:t>EXCLUDE</a:t>
              </a:r>
            </a:p>
            <a:p>
              <a:pPr algn="ctr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=189</a:t>
              </a:r>
            </a:p>
          </p:txBody>
        </p: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id="{E427E08E-5432-3A4D-C1E6-AC506D9DFCBA}"/>
                </a:ext>
              </a:extLst>
            </p:cNvPr>
            <p:cNvSpPr/>
            <p:nvPr/>
          </p:nvSpPr>
          <p:spPr>
            <a:xfrm>
              <a:off x="2323984" y="7016845"/>
              <a:ext cx="1105015" cy="292460"/>
            </a:xfrm>
            <a:custGeom>
              <a:avLst/>
              <a:gdLst>
                <a:gd name="connsiteX0" fmla="*/ 1105015 w 1105015"/>
                <a:gd name="connsiteY0" fmla="*/ 0 h 292460"/>
                <a:gd name="connsiteX1" fmla="*/ 1105015 w 1105015"/>
                <a:gd name="connsiteY1" fmla="*/ 184169 h 292460"/>
                <a:gd name="connsiteX2" fmla="*/ 0 w 1105015"/>
                <a:gd name="connsiteY2" fmla="*/ 184169 h 292460"/>
                <a:gd name="connsiteX3" fmla="*/ 0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1105015" y="0"/>
                  </a:moveTo>
                  <a:lnTo>
                    <a:pt x="1105015" y="184169"/>
                  </a:lnTo>
                  <a:lnTo>
                    <a:pt x="0" y="184169"/>
                  </a:ln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id="{4048197B-D970-10C4-BC6C-71BE2F4711E3}"/>
                </a:ext>
              </a:extLst>
            </p:cNvPr>
            <p:cNvSpPr/>
            <p:nvPr/>
          </p:nvSpPr>
          <p:spPr>
            <a:xfrm>
              <a:off x="2287151" y="7290889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9688D62-1C02-5A45-C43B-969795A7137A}"/>
                </a:ext>
              </a:extLst>
            </p:cNvPr>
            <p:cNvSpPr txBox="1"/>
            <p:nvPr/>
          </p:nvSpPr>
          <p:spPr>
            <a:xfrm>
              <a:off x="2642321" y="7077642"/>
              <a:ext cx="477550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YES</a:t>
              </a:r>
            </a:p>
          </p:txBody>
        </p:sp>
        <p:sp>
          <p:nvSpPr>
            <p:cNvPr id="63" name="Freeform 62">
              <a:extLst>
                <a:ext uri="{FF2B5EF4-FFF2-40B4-BE49-F238E27FC236}">
                  <a16:creationId xmlns:a16="http://schemas.microsoft.com/office/drawing/2014/main" id="{21C09EDE-B5FB-F8E0-EBFD-F202D87E7B37}"/>
                </a:ext>
              </a:extLst>
            </p:cNvPr>
            <p:cNvSpPr/>
            <p:nvPr/>
          </p:nvSpPr>
          <p:spPr>
            <a:xfrm>
              <a:off x="3429000" y="7016845"/>
              <a:ext cx="1105015" cy="292460"/>
            </a:xfrm>
            <a:custGeom>
              <a:avLst/>
              <a:gdLst>
                <a:gd name="connsiteX0" fmla="*/ 0 w 1105015"/>
                <a:gd name="connsiteY0" fmla="*/ 0 h 292460"/>
                <a:gd name="connsiteX1" fmla="*/ 0 w 1105015"/>
                <a:gd name="connsiteY1" fmla="*/ 184169 h 292460"/>
                <a:gd name="connsiteX2" fmla="*/ 1105015 w 1105015"/>
                <a:gd name="connsiteY2" fmla="*/ 184169 h 292460"/>
                <a:gd name="connsiteX3" fmla="*/ 1105015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0" y="0"/>
                  </a:moveTo>
                  <a:lnTo>
                    <a:pt x="0" y="184169"/>
                  </a:lnTo>
                  <a:lnTo>
                    <a:pt x="1105015" y="184169"/>
                  </a:lnTo>
                  <a:lnTo>
                    <a:pt x="1105015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528B6397-FCFA-EAF7-926C-D377D143F5C6}"/>
                </a:ext>
              </a:extLst>
            </p:cNvPr>
            <p:cNvSpPr/>
            <p:nvPr/>
          </p:nvSpPr>
          <p:spPr>
            <a:xfrm>
              <a:off x="4497181" y="7290889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8842AAE-3691-BBFD-9EF4-938DDFE0FFD3}"/>
                </a:ext>
              </a:extLst>
            </p:cNvPr>
            <p:cNvSpPr txBox="1"/>
            <p:nvPr/>
          </p:nvSpPr>
          <p:spPr>
            <a:xfrm>
              <a:off x="3784170" y="7068434"/>
              <a:ext cx="403883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O</a:t>
              </a:r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id="{847BC1D3-7575-E24F-B6A9-3B0DA5751104}"/>
                </a:ext>
              </a:extLst>
            </p:cNvPr>
            <p:cNvSpPr/>
            <p:nvPr/>
          </p:nvSpPr>
          <p:spPr>
            <a:xfrm>
              <a:off x="1403138" y="6648507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7" name="Freeform 66">
              <a:extLst>
                <a:ext uri="{FF2B5EF4-FFF2-40B4-BE49-F238E27FC236}">
                  <a16:creationId xmlns:a16="http://schemas.microsoft.com/office/drawing/2014/main" id="{B3C0CACB-1B3B-6D78-3218-7445856FBE61}"/>
                </a:ext>
              </a:extLst>
            </p:cNvPr>
            <p:cNvSpPr/>
            <p:nvPr/>
          </p:nvSpPr>
          <p:spPr>
            <a:xfrm>
              <a:off x="1403138" y="6648507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8" name="Freeform 67">
              <a:extLst>
                <a:ext uri="{FF2B5EF4-FFF2-40B4-BE49-F238E27FC236}">
                  <a16:creationId xmlns:a16="http://schemas.microsoft.com/office/drawing/2014/main" id="{1B420643-47EE-A8A5-6075-7AFE979CB429}"/>
                </a:ext>
              </a:extLst>
            </p:cNvPr>
            <p:cNvSpPr/>
            <p:nvPr/>
          </p:nvSpPr>
          <p:spPr>
            <a:xfrm>
              <a:off x="1403138" y="6648507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moveTo>
                    <a:pt x="4051722" y="368338"/>
                  </a:moveTo>
                  <a:lnTo>
                    <a:pt x="0" y="368338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4FFDD99-F940-F525-2B13-4FCF7D82D770}"/>
                </a:ext>
              </a:extLst>
            </p:cNvPr>
            <p:cNvSpPr txBox="1"/>
            <p:nvPr/>
          </p:nvSpPr>
          <p:spPr>
            <a:xfrm>
              <a:off x="2264774" y="6698804"/>
              <a:ext cx="2319242" cy="238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Delivery gestation &lt;34w or ≥37w</a:t>
              </a:r>
            </a:p>
          </p:txBody>
        </p:sp>
        <p:sp>
          <p:nvSpPr>
            <p:cNvPr id="70" name="Freeform 69">
              <a:extLst>
                <a:ext uri="{FF2B5EF4-FFF2-40B4-BE49-F238E27FC236}">
                  <a16:creationId xmlns:a16="http://schemas.microsoft.com/office/drawing/2014/main" id="{49A343E4-CD97-4C52-8B96-2F967526D2AC}"/>
                </a:ext>
              </a:extLst>
            </p:cNvPr>
            <p:cNvSpPr/>
            <p:nvPr/>
          </p:nvSpPr>
          <p:spPr>
            <a:xfrm>
              <a:off x="2323984" y="8121861"/>
              <a:ext cx="9208" cy="292460"/>
            </a:xfrm>
            <a:custGeom>
              <a:avLst/>
              <a:gdLst>
                <a:gd name="connsiteX0" fmla="*/ 0 w 9208"/>
                <a:gd name="connsiteY0" fmla="*/ 0 h 292460"/>
                <a:gd name="connsiteX1" fmla="*/ 0 w 9208"/>
                <a:gd name="connsiteY1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08" h="292460">
                  <a:moveTo>
                    <a:pt x="0" y="0"/>
                  </a:move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1" name="Freeform 70">
              <a:extLst>
                <a:ext uri="{FF2B5EF4-FFF2-40B4-BE49-F238E27FC236}">
                  <a16:creationId xmlns:a16="http://schemas.microsoft.com/office/drawing/2014/main" id="{02EAD937-BCF3-8F55-A00D-CB1C76C430B9}"/>
                </a:ext>
              </a:extLst>
            </p:cNvPr>
            <p:cNvSpPr/>
            <p:nvPr/>
          </p:nvSpPr>
          <p:spPr>
            <a:xfrm>
              <a:off x="2287151" y="8395904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2" name="Freeform 71">
              <a:extLst>
                <a:ext uri="{FF2B5EF4-FFF2-40B4-BE49-F238E27FC236}">
                  <a16:creationId xmlns:a16="http://schemas.microsoft.com/office/drawing/2014/main" id="{41E6D2B1-6B51-A5DB-F9A7-38CF03144A28}"/>
                </a:ext>
              </a:extLst>
            </p:cNvPr>
            <p:cNvSpPr/>
            <p:nvPr/>
          </p:nvSpPr>
          <p:spPr>
            <a:xfrm>
              <a:off x="2323984" y="8121861"/>
              <a:ext cx="2210030" cy="292460"/>
            </a:xfrm>
            <a:custGeom>
              <a:avLst/>
              <a:gdLst>
                <a:gd name="connsiteX0" fmla="*/ 0 w 2210030"/>
                <a:gd name="connsiteY0" fmla="*/ 0 h 292460"/>
                <a:gd name="connsiteX1" fmla="*/ 0 w 2210030"/>
                <a:gd name="connsiteY1" fmla="*/ 184169 h 292460"/>
                <a:gd name="connsiteX2" fmla="*/ 2210030 w 2210030"/>
                <a:gd name="connsiteY2" fmla="*/ 184169 h 292460"/>
                <a:gd name="connsiteX3" fmla="*/ 2210030 w 2210030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210030" h="292460">
                  <a:moveTo>
                    <a:pt x="0" y="0"/>
                  </a:moveTo>
                  <a:lnTo>
                    <a:pt x="0" y="184169"/>
                  </a:lnTo>
                  <a:lnTo>
                    <a:pt x="2210030" y="184169"/>
                  </a:lnTo>
                  <a:lnTo>
                    <a:pt x="221003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3" name="Freeform 72">
              <a:extLst>
                <a:ext uri="{FF2B5EF4-FFF2-40B4-BE49-F238E27FC236}">
                  <a16:creationId xmlns:a16="http://schemas.microsoft.com/office/drawing/2014/main" id="{2B4DAA64-E1A0-B449-C3C5-738B8600AA74}"/>
                </a:ext>
              </a:extLst>
            </p:cNvPr>
            <p:cNvSpPr/>
            <p:nvPr/>
          </p:nvSpPr>
          <p:spPr>
            <a:xfrm>
              <a:off x="4497181" y="8395904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4" name="Freeform 73">
              <a:extLst>
                <a:ext uri="{FF2B5EF4-FFF2-40B4-BE49-F238E27FC236}">
                  <a16:creationId xmlns:a16="http://schemas.microsoft.com/office/drawing/2014/main" id="{A092CC15-F0A7-A2C5-80A6-2314B7529F38}"/>
                </a:ext>
              </a:extLst>
            </p:cNvPr>
            <p:cNvSpPr/>
            <p:nvPr/>
          </p:nvSpPr>
          <p:spPr>
            <a:xfrm>
              <a:off x="1403138" y="7385184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FFFFF"/>
            </a:solidFill>
            <a:ln w="36813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EFD6604E-72D2-2C67-85B7-287E6AB01BE6}"/>
                </a:ext>
              </a:extLst>
            </p:cNvPr>
            <p:cNvSpPr txBox="1"/>
            <p:nvPr/>
          </p:nvSpPr>
          <p:spPr>
            <a:xfrm>
              <a:off x="1818164" y="7423403"/>
              <a:ext cx="987728" cy="661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INCLUDE</a:t>
              </a:r>
            </a:p>
            <a:p>
              <a:pPr algn="ctr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&lt;34w, n=70</a:t>
              </a:r>
            </a:p>
            <a:p>
              <a:pPr algn="ctr"/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≥37w, n=292</a:t>
              </a:r>
              <a:endParaRPr lang="en-US" sz="1160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76" name="Freeform 75">
              <a:extLst>
                <a:ext uri="{FF2B5EF4-FFF2-40B4-BE49-F238E27FC236}">
                  <a16:creationId xmlns:a16="http://schemas.microsoft.com/office/drawing/2014/main" id="{AAE02566-3AF1-4271-FA06-DB2331E428F7}"/>
                </a:ext>
              </a:extLst>
            </p:cNvPr>
            <p:cNvSpPr/>
            <p:nvPr/>
          </p:nvSpPr>
          <p:spPr>
            <a:xfrm>
              <a:off x="3613169" y="7385184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5F5F5"/>
            </a:solidFill>
            <a:ln w="18406" cap="flat">
              <a:solidFill>
                <a:srgbClr val="666666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2543EDF9-F048-5ABA-43D2-4E0A445C7276}"/>
                </a:ext>
              </a:extLst>
            </p:cNvPr>
            <p:cNvSpPr txBox="1"/>
            <p:nvPr/>
          </p:nvSpPr>
          <p:spPr>
            <a:xfrm>
              <a:off x="4113713" y="7521341"/>
              <a:ext cx="840600" cy="4737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333333"/>
                  </a:solidFill>
                  <a:latin typeface="Helvetica"/>
                  <a:sym typeface="Helvetica"/>
                  <a:rtl val="0"/>
                </a:rPr>
                <a:t>EXCLUDE</a:t>
              </a:r>
            </a:p>
            <a:p>
              <a:pPr algn="ctr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=70</a:t>
              </a:r>
              <a:endParaRPr lang="en-US" sz="1160" spc="0" baseline="0" dirty="0">
                <a:solidFill>
                  <a:srgbClr val="333333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78" name="Freeform 77">
              <a:extLst>
                <a:ext uri="{FF2B5EF4-FFF2-40B4-BE49-F238E27FC236}">
                  <a16:creationId xmlns:a16="http://schemas.microsoft.com/office/drawing/2014/main" id="{7DA9FA1B-EC80-74C9-CA60-2B97F74C5C6A}"/>
                </a:ext>
              </a:extLst>
            </p:cNvPr>
            <p:cNvSpPr/>
            <p:nvPr/>
          </p:nvSpPr>
          <p:spPr>
            <a:xfrm>
              <a:off x="2323984" y="8858537"/>
              <a:ext cx="9208" cy="292460"/>
            </a:xfrm>
            <a:custGeom>
              <a:avLst/>
              <a:gdLst>
                <a:gd name="connsiteX0" fmla="*/ 0 w 9208"/>
                <a:gd name="connsiteY0" fmla="*/ 0 h 292460"/>
                <a:gd name="connsiteX1" fmla="*/ 0 w 9208"/>
                <a:gd name="connsiteY1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08" h="292460">
                  <a:moveTo>
                    <a:pt x="0" y="0"/>
                  </a:move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79" name="Freeform 78">
              <a:extLst>
                <a:ext uri="{FF2B5EF4-FFF2-40B4-BE49-F238E27FC236}">
                  <a16:creationId xmlns:a16="http://schemas.microsoft.com/office/drawing/2014/main" id="{040DE3B6-C1A6-2237-FA22-735BEB2C756F}"/>
                </a:ext>
              </a:extLst>
            </p:cNvPr>
            <p:cNvSpPr/>
            <p:nvPr/>
          </p:nvSpPr>
          <p:spPr>
            <a:xfrm>
              <a:off x="2287151" y="9132581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0" name="Freeform 79">
              <a:extLst>
                <a:ext uri="{FF2B5EF4-FFF2-40B4-BE49-F238E27FC236}">
                  <a16:creationId xmlns:a16="http://schemas.microsoft.com/office/drawing/2014/main" id="{D6EF0E67-FAAE-0686-50B9-22ED4EA137B6}"/>
                </a:ext>
              </a:extLst>
            </p:cNvPr>
            <p:cNvSpPr/>
            <p:nvPr/>
          </p:nvSpPr>
          <p:spPr>
            <a:xfrm>
              <a:off x="1403138" y="8490199"/>
              <a:ext cx="1841691" cy="368338"/>
            </a:xfrm>
            <a:custGeom>
              <a:avLst/>
              <a:gdLst>
                <a:gd name="connsiteX0" fmla="*/ 0 w 1841691"/>
                <a:gd name="connsiteY0" fmla="*/ 0 h 368338"/>
                <a:gd name="connsiteX1" fmla="*/ 1841692 w 1841691"/>
                <a:gd name="connsiteY1" fmla="*/ 0 h 368338"/>
                <a:gd name="connsiteX2" fmla="*/ 1841692 w 1841691"/>
                <a:gd name="connsiteY2" fmla="*/ 368338 h 368338"/>
                <a:gd name="connsiteX3" fmla="*/ 0 w 1841691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368338">
                  <a:moveTo>
                    <a:pt x="0" y="0"/>
                  </a:moveTo>
                  <a:lnTo>
                    <a:pt x="1841692" y="0"/>
                  </a:lnTo>
                  <a:lnTo>
                    <a:pt x="184169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1" name="Freeform 80">
              <a:extLst>
                <a:ext uri="{FF2B5EF4-FFF2-40B4-BE49-F238E27FC236}">
                  <a16:creationId xmlns:a16="http://schemas.microsoft.com/office/drawing/2014/main" id="{D359681A-0A23-4D0D-463A-A2306272F0B8}"/>
                </a:ext>
              </a:extLst>
            </p:cNvPr>
            <p:cNvSpPr/>
            <p:nvPr/>
          </p:nvSpPr>
          <p:spPr>
            <a:xfrm>
              <a:off x="1403138" y="8490199"/>
              <a:ext cx="1841691" cy="368338"/>
            </a:xfrm>
            <a:custGeom>
              <a:avLst/>
              <a:gdLst>
                <a:gd name="connsiteX0" fmla="*/ 0 w 1841691"/>
                <a:gd name="connsiteY0" fmla="*/ 0 h 368338"/>
                <a:gd name="connsiteX1" fmla="*/ 1841692 w 1841691"/>
                <a:gd name="connsiteY1" fmla="*/ 0 h 368338"/>
                <a:gd name="connsiteX2" fmla="*/ 1841692 w 1841691"/>
                <a:gd name="connsiteY2" fmla="*/ 368338 h 368338"/>
                <a:gd name="connsiteX3" fmla="*/ 0 w 1841691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368338">
                  <a:moveTo>
                    <a:pt x="0" y="0"/>
                  </a:moveTo>
                  <a:lnTo>
                    <a:pt x="1841692" y="0"/>
                  </a:lnTo>
                  <a:lnTo>
                    <a:pt x="184169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2" name="Freeform 81">
              <a:extLst>
                <a:ext uri="{FF2B5EF4-FFF2-40B4-BE49-F238E27FC236}">
                  <a16:creationId xmlns:a16="http://schemas.microsoft.com/office/drawing/2014/main" id="{76E134EB-2580-5480-C096-1845EFFB1105}"/>
                </a:ext>
              </a:extLst>
            </p:cNvPr>
            <p:cNvSpPr/>
            <p:nvPr/>
          </p:nvSpPr>
          <p:spPr>
            <a:xfrm>
              <a:off x="1403138" y="8490199"/>
              <a:ext cx="1841691" cy="368338"/>
            </a:xfrm>
            <a:custGeom>
              <a:avLst/>
              <a:gdLst>
                <a:gd name="connsiteX0" fmla="*/ 0 w 1841691"/>
                <a:gd name="connsiteY0" fmla="*/ 0 h 368338"/>
                <a:gd name="connsiteX1" fmla="*/ 1841692 w 1841691"/>
                <a:gd name="connsiteY1" fmla="*/ 0 h 368338"/>
                <a:gd name="connsiteX2" fmla="*/ 1841692 w 1841691"/>
                <a:gd name="connsiteY2" fmla="*/ 368338 h 368338"/>
                <a:gd name="connsiteX3" fmla="*/ 0 w 1841691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368338">
                  <a:moveTo>
                    <a:pt x="0" y="0"/>
                  </a:moveTo>
                  <a:lnTo>
                    <a:pt x="1841692" y="0"/>
                  </a:lnTo>
                  <a:moveTo>
                    <a:pt x="1841692" y="368338"/>
                  </a:moveTo>
                  <a:lnTo>
                    <a:pt x="0" y="368338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3F455FA-5598-A2F6-A4F6-7C7EBAC37D32}"/>
                </a:ext>
              </a:extLst>
            </p:cNvPr>
            <p:cNvSpPr txBox="1"/>
            <p:nvPr/>
          </p:nvSpPr>
          <p:spPr>
            <a:xfrm>
              <a:off x="1445221" y="8540497"/>
              <a:ext cx="1757526" cy="238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Delivery gestation &lt;34w</a:t>
              </a:r>
            </a:p>
          </p:txBody>
        </p:sp>
        <p:sp>
          <p:nvSpPr>
            <p:cNvPr id="84" name="Freeform 83">
              <a:extLst>
                <a:ext uri="{FF2B5EF4-FFF2-40B4-BE49-F238E27FC236}">
                  <a16:creationId xmlns:a16="http://schemas.microsoft.com/office/drawing/2014/main" id="{C9EA056E-1B98-B9BB-9094-0349940B9E2C}"/>
                </a:ext>
              </a:extLst>
            </p:cNvPr>
            <p:cNvSpPr/>
            <p:nvPr/>
          </p:nvSpPr>
          <p:spPr>
            <a:xfrm>
              <a:off x="4534015" y="8858537"/>
              <a:ext cx="9208" cy="292460"/>
            </a:xfrm>
            <a:custGeom>
              <a:avLst/>
              <a:gdLst>
                <a:gd name="connsiteX0" fmla="*/ 0 w 9208"/>
                <a:gd name="connsiteY0" fmla="*/ 0 h 292460"/>
                <a:gd name="connsiteX1" fmla="*/ 0 w 9208"/>
                <a:gd name="connsiteY1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08" h="292460">
                  <a:moveTo>
                    <a:pt x="0" y="0"/>
                  </a:move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5" name="Freeform 84">
              <a:extLst>
                <a:ext uri="{FF2B5EF4-FFF2-40B4-BE49-F238E27FC236}">
                  <a16:creationId xmlns:a16="http://schemas.microsoft.com/office/drawing/2014/main" id="{2813A842-5C42-D4A7-6854-E42DAF4FC3F1}"/>
                </a:ext>
              </a:extLst>
            </p:cNvPr>
            <p:cNvSpPr/>
            <p:nvPr/>
          </p:nvSpPr>
          <p:spPr>
            <a:xfrm>
              <a:off x="4497181" y="9132581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6" name="Freeform 85">
              <a:extLst>
                <a:ext uri="{FF2B5EF4-FFF2-40B4-BE49-F238E27FC236}">
                  <a16:creationId xmlns:a16="http://schemas.microsoft.com/office/drawing/2014/main" id="{7B8AB9C0-BFAE-5ABF-8696-CED1D75CE0AA}"/>
                </a:ext>
              </a:extLst>
            </p:cNvPr>
            <p:cNvSpPr/>
            <p:nvPr/>
          </p:nvSpPr>
          <p:spPr>
            <a:xfrm>
              <a:off x="3613169" y="8490199"/>
              <a:ext cx="1841691" cy="368338"/>
            </a:xfrm>
            <a:custGeom>
              <a:avLst/>
              <a:gdLst>
                <a:gd name="connsiteX0" fmla="*/ 0 w 1841691"/>
                <a:gd name="connsiteY0" fmla="*/ 0 h 368338"/>
                <a:gd name="connsiteX1" fmla="*/ 1841692 w 1841691"/>
                <a:gd name="connsiteY1" fmla="*/ 0 h 368338"/>
                <a:gd name="connsiteX2" fmla="*/ 1841692 w 1841691"/>
                <a:gd name="connsiteY2" fmla="*/ 368338 h 368338"/>
                <a:gd name="connsiteX3" fmla="*/ 0 w 1841691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368338">
                  <a:moveTo>
                    <a:pt x="0" y="0"/>
                  </a:moveTo>
                  <a:lnTo>
                    <a:pt x="1841692" y="0"/>
                  </a:lnTo>
                  <a:lnTo>
                    <a:pt x="184169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7" name="Freeform 86">
              <a:extLst>
                <a:ext uri="{FF2B5EF4-FFF2-40B4-BE49-F238E27FC236}">
                  <a16:creationId xmlns:a16="http://schemas.microsoft.com/office/drawing/2014/main" id="{8411A66C-A06F-1471-1D96-BB741FF5372C}"/>
                </a:ext>
              </a:extLst>
            </p:cNvPr>
            <p:cNvSpPr/>
            <p:nvPr/>
          </p:nvSpPr>
          <p:spPr>
            <a:xfrm>
              <a:off x="3613169" y="8490199"/>
              <a:ext cx="1841691" cy="368338"/>
            </a:xfrm>
            <a:custGeom>
              <a:avLst/>
              <a:gdLst>
                <a:gd name="connsiteX0" fmla="*/ 0 w 1841691"/>
                <a:gd name="connsiteY0" fmla="*/ 0 h 368338"/>
                <a:gd name="connsiteX1" fmla="*/ 1841692 w 1841691"/>
                <a:gd name="connsiteY1" fmla="*/ 0 h 368338"/>
                <a:gd name="connsiteX2" fmla="*/ 1841692 w 1841691"/>
                <a:gd name="connsiteY2" fmla="*/ 368338 h 368338"/>
                <a:gd name="connsiteX3" fmla="*/ 0 w 1841691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368338">
                  <a:moveTo>
                    <a:pt x="0" y="0"/>
                  </a:moveTo>
                  <a:lnTo>
                    <a:pt x="1841692" y="0"/>
                  </a:lnTo>
                  <a:lnTo>
                    <a:pt x="184169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8" name="Freeform 87">
              <a:extLst>
                <a:ext uri="{FF2B5EF4-FFF2-40B4-BE49-F238E27FC236}">
                  <a16:creationId xmlns:a16="http://schemas.microsoft.com/office/drawing/2014/main" id="{0AB74243-AB3F-A4B9-BF30-A4C87036BC99}"/>
                </a:ext>
              </a:extLst>
            </p:cNvPr>
            <p:cNvSpPr/>
            <p:nvPr/>
          </p:nvSpPr>
          <p:spPr>
            <a:xfrm>
              <a:off x="3613169" y="8490199"/>
              <a:ext cx="1841691" cy="368338"/>
            </a:xfrm>
            <a:custGeom>
              <a:avLst/>
              <a:gdLst>
                <a:gd name="connsiteX0" fmla="*/ 0 w 1841691"/>
                <a:gd name="connsiteY0" fmla="*/ 0 h 368338"/>
                <a:gd name="connsiteX1" fmla="*/ 1841692 w 1841691"/>
                <a:gd name="connsiteY1" fmla="*/ 0 h 368338"/>
                <a:gd name="connsiteX2" fmla="*/ 1841692 w 1841691"/>
                <a:gd name="connsiteY2" fmla="*/ 368338 h 368338"/>
                <a:gd name="connsiteX3" fmla="*/ 0 w 1841691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368338">
                  <a:moveTo>
                    <a:pt x="0" y="0"/>
                  </a:moveTo>
                  <a:lnTo>
                    <a:pt x="1841692" y="0"/>
                  </a:lnTo>
                  <a:moveTo>
                    <a:pt x="1841692" y="368338"/>
                  </a:moveTo>
                  <a:lnTo>
                    <a:pt x="0" y="368338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0A7B71D6-069C-329F-2C54-50C2426CD1EF}"/>
                </a:ext>
              </a:extLst>
            </p:cNvPr>
            <p:cNvSpPr txBox="1"/>
            <p:nvPr/>
          </p:nvSpPr>
          <p:spPr>
            <a:xfrm>
              <a:off x="3636834" y="8530952"/>
              <a:ext cx="1794360" cy="238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Delivery gestation  ≥37w</a:t>
              </a:r>
            </a:p>
          </p:txBody>
        </p:sp>
        <p:sp>
          <p:nvSpPr>
            <p:cNvPr id="90" name="Freeform 89">
              <a:extLst>
                <a:ext uri="{FF2B5EF4-FFF2-40B4-BE49-F238E27FC236}">
                  <a16:creationId xmlns:a16="http://schemas.microsoft.com/office/drawing/2014/main" id="{1AFB5DF5-567A-E47E-B520-30AF90F708F3}"/>
                </a:ext>
              </a:extLst>
            </p:cNvPr>
            <p:cNvSpPr/>
            <p:nvPr/>
          </p:nvSpPr>
          <p:spPr>
            <a:xfrm>
              <a:off x="2323984" y="10331891"/>
              <a:ext cx="1105015" cy="292460"/>
            </a:xfrm>
            <a:custGeom>
              <a:avLst/>
              <a:gdLst>
                <a:gd name="connsiteX0" fmla="*/ 0 w 1105015"/>
                <a:gd name="connsiteY0" fmla="*/ 0 h 292460"/>
                <a:gd name="connsiteX1" fmla="*/ 0 w 1105015"/>
                <a:gd name="connsiteY1" fmla="*/ 184169 h 292460"/>
                <a:gd name="connsiteX2" fmla="*/ 1105015 w 1105015"/>
                <a:gd name="connsiteY2" fmla="*/ 184169 h 292460"/>
                <a:gd name="connsiteX3" fmla="*/ 1105015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0" y="0"/>
                  </a:moveTo>
                  <a:lnTo>
                    <a:pt x="0" y="184169"/>
                  </a:lnTo>
                  <a:lnTo>
                    <a:pt x="1105015" y="184169"/>
                  </a:lnTo>
                  <a:lnTo>
                    <a:pt x="1105015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1" name="Freeform 90">
              <a:extLst>
                <a:ext uri="{FF2B5EF4-FFF2-40B4-BE49-F238E27FC236}">
                  <a16:creationId xmlns:a16="http://schemas.microsoft.com/office/drawing/2014/main" id="{655BF8C4-932E-A00D-E1B3-F57BFBEF30A2}"/>
                </a:ext>
              </a:extLst>
            </p:cNvPr>
            <p:cNvSpPr/>
            <p:nvPr/>
          </p:nvSpPr>
          <p:spPr>
            <a:xfrm>
              <a:off x="3392166" y="10605935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2" name="Freeform 91">
              <a:extLst>
                <a:ext uri="{FF2B5EF4-FFF2-40B4-BE49-F238E27FC236}">
                  <a16:creationId xmlns:a16="http://schemas.microsoft.com/office/drawing/2014/main" id="{3D511F90-2ED2-CF4D-E92D-734368AA4D54}"/>
                </a:ext>
              </a:extLst>
            </p:cNvPr>
            <p:cNvSpPr/>
            <p:nvPr/>
          </p:nvSpPr>
          <p:spPr>
            <a:xfrm>
              <a:off x="1403138" y="9226876"/>
              <a:ext cx="1841691" cy="1105015"/>
            </a:xfrm>
            <a:custGeom>
              <a:avLst/>
              <a:gdLst>
                <a:gd name="connsiteX0" fmla="*/ 0 w 1841691"/>
                <a:gd name="connsiteY0" fmla="*/ 0 h 1105015"/>
                <a:gd name="connsiteX1" fmla="*/ 1841692 w 1841691"/>
                <a:gd name="connsiteY1" fmla="*/ 0 h 1105015"/>
                <a:gd name="connsiteX2" fmla="*/ 1841692 w 1841691"/>
                <a:gd name="connsiteY2" fmla="*/ 1105015 h 1105015"/>
                <a:gd name="connsiteX3" fmla="*/ 0 w 1841691"/>
                <a:gd name="connsiteY3" fmla="*/ 1105015 h 11050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1105015">
                  <a:moveTo>
                    <a:pt x="0" y="0"/>
                  </a:moveTo>
                  <a:lnTo>
                    <a:pt x="1841692" y="0"/>
                  </a:lnTo>
                  <a:lnTo>
                    <a:pt x="1841692" y="1105015"/>
                  </a:lnTo>
                  <a:lnTo>
                    <a:pt x="0" y="1105015"/>
                  </a:lnTo>
                  <a:close/>
                </a:path>
              </a:pathLst>
            </a:custGeom>
            <a:solidFill>
              <a:srgbClr val="FFFFFF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1FF67DC1-BC10-BD74-F5C2-E62F325C1F28}"/>
                </a:ext>
              </a:extLst>
            </p:cNvPr>
            <p:cNvSpPr txBox="1"/>
            <p:nvPr/>
          </p:nvSpPr>
          <p:spPr>
            <a:xfrm>
              <a:off x="1427810" y="9274405"/>
              <a:ext cx="1774937" cy="10383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MISSING DATA</a:t>
              </a:r>
            </a:p>
            <a:p>
              <a:pPr algn="ctr"/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BMI, </a:t>
              </a:r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=3</a:t>
              </a:r>
            </a:p>
            <a:p>
              <a:pPr algn="ctr"/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Ethnicity (Simplified), n=2</a:t>
              </a:r>
            </a:p>
            <a:p>
              <a:pPr algn="ctr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Smoking Status, n=3</a:t>
              </a:r>
            </a:p>
            <a:p>
              <a:pPr algn="ctr"/>
              <a:endParaRPr lang="en-US" sz="1160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94" name="Freeform 93">
              <a:extLst>
                <a:ext uri="{FF2B5EF4-FFF2-40B4-BE49-F238E27FC236}">
                  <a16:creationId xmlns:a16="http://schemas.microsoft.com/office/drawing/2014/main" id="{C82426EB-1727-E8EA-E96B-6C710AA70C23}"/>
                </a:ext>
              </a:extLst>
            </p:cNvPr>
            <p:cNvSpPr/>
            <p:nvPr/>
          </p:nvSpPr>
          <p:spPr>
            <a:xfrm>
              <a:off x="3429000" y="10331891"/>
              <a:ext cx="1105015" cy="292460"/>
            </a:xfrm>
            <a:custGeom>
              <a:avLst/>
              <a:gdLst>
                <a:gd name="connsiteX0" fmla="*/ 1105015 w 1105015"/>
                <a:gd name="connsiteY0" fmla="*/ 0 h 292460"/>
                <a:gd name="connsiteX1" fmla="*/ 1105015 w 1105015"/>
                <a:gd name="connsiteY1" fmla="*/ 184169 h 292460"/>
                <a:gd name="connsiteX2" fmla="*/ 0 w 1105015"/>
                <a:gd name="connsiteY2" fmla="*/ 184169 h 292460"/>
                <a:gd name="connsiteX3" fmla="*/ 0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1105015" y="0"/>
                  </a:moveTo>
                  <a:lnTo>
                    <a:pt x="1105015" y="184169"/>
                  </a:lnTo>
                  <a:lnTo>
                    <a:pt x="0" y="184169"/>
                  </a:ln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5" name="Freeform 94">
              <a:extLst>
                <a:ext uri="{FF2B5EF4-FFF2-40B4-BE49-F238E27FC236}">
                  <a16:creationId xmlns:a16="http://schemas.microsoft.com/office/drawing/2014/main" id="{9B9726F7-6863-5A6C-C126-BD9318E3D2CE}"/>
                </a:ext>
              </a:extLst>
            </p:cNvPr>
            <p:cNvSpPr/>
            <p:nvPr/>
          </p:nvSpPr>
          <p:spPr>
            <a:xfrm>
              <a:off x="3392166" y="10605935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6" name="Freeform 95">
              <a:extLst>
                <a:ext uri="{FF2B5EF4-FFF2-40B4-BE49-F238E27FC236}">
                  <a16:creationId xmlns:a16="http://schemas.microsoft.com/office/drawing/2014/main" id="{76004A9C-654A-0895-9E32-43E7C60517B9}"/>
                </a:ext>
              </a:extLst>
            </p:cNvPr>
            <p:cNvSpPr/>
            <p:nvPr/>
          </p:nvSpPr>
          <p:spPr>
            <a:xfrm>
              <a:off x="3613169" y="9226876"/>
              <a:ext cx="1841691" cy="1105015"/>
            </a:xfrm>
            <a:custGeom>
              <a:avLst/>
              <a:gdLst>
                <a:gd name="connsiteX0" fmla="*/ 0 w 1841691"/>
                <a:gd name="connsiteY0" fmla="*/ 0 h 1105015"/>
                <a:gd name="connsiteX1" fmla="*/ 1841692 w 1841691"/>
                <a:gd name="connsiteY1" fmla="*/ 0 h 1105015"/>
                <a:gd name="connsiteX2" fmla="*/ 1841692 w 1841691"/>
                <a:gd name="connsiteY2" fmla="*/ 1105015 h 1105015"/>
                <a:gd name="connsiteX3" fmla="*/ 0 w 1841691"/>
                <a:gd name="connsiteY3" fmla="*/ 1105015 h 11050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1105015">
                  <a:moveTo>
                    <a:pt x="0" y="0"/>
                  </a:moveTo>
                  <a:lnTo>
                    <a:pt x="1841692" y="0"/>
                  </a:lnTo>
                  <a:lnTo>
                    <a:pt x="1841692" y="1105015"/>
                  </a:lnTo>
                  <a:lnTo>
                    <a:pt x="0" y="1105015"/>
                  </a:lnTo>
                  <a:close/>
                </a:path>
              </a:pathLst>
            </a:custGeom>
            <a:solidFill>
              <a:srgbClr val="FFFFFF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8" name="Freeform 97">
              <a:extLst>
                <a:ext uri="{FF2B5EF4-FFF2-40B4-BE49-F238E27FC236}">
                  <a16:creationId xmlns:a16="http://schemas.microsoft.com/office/drawing/2014/main" id="{0A486BF3-C9CE-2BE4-1068-36957B2D723E}"/>
                </a:ext>
              </a:extLst>
            </p:cNvPr>
            <p:cNvSpPr/>
            <p:nvPr/>
          </p:nvSpPr>
          <p:spPr>
            <a:xfrm>
              <a:off x="2323984" y="11068567"/>
              <a:ext cx="1105015" cy="292460"/>
            </a:xfrm>
            <a:custGeom>
              <a:avLst/>
              <a:gdLst>
                <a:gd name="connsiteX0" fmla="*/ 1105015 w 1105015"/>
                <a:gd name="connsiteY0" fmla="*/ 0 h 292460"/>
                <a:gd name="connsiteX1" fmla="*/ 1105015 w 1105015"/>
                <a:gd name="connsiteY1" fmla="*/ 184169 h 292460"/>
                <a:gd name="connsiteX2" fmla="*/ 0 w 1105015"/>
                <a:gd name="connsiteY2" fmla="*/ 184169 h 292460"/>
                <a:gd name="connsiteX3" fmla="*/ 0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1105015" y="0"/>
                  </a:moveTo>
                  <a:lnTo>
                    <a:pt x="1105015" y="184169"/>
                  </a:lnTo>
                  <a:lnTo>
                    <a:pt x="0" y="184169"/>
                  </a:lnTo>
                  <a:lnTo>
                    <a:pt x="0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99" name="Freeform 98">
              <a:extLst>
                <a:ext uri="{FF2B5EF4-FFF2-40B4-BE49-F238E27FC236}">
                  <a16:creationId xmlns:a16="http://schemas.microsoft.com/office/drawing/2014/main" id="{C426A3D1-0DA1-9A20-D354-797F7FA09D86}"/>
                </a:ext>
              </a:extLst>
            </p:cNvPr>
            <p:cNvSpPr/>
            <p:nvPr/>
          </p:nvSpPr>
          <p:spPr>
            <a:xfrm>
              <a:off x="2287151" y="11342611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F7633602-6907-AA5D-2ACF-6F481BB6A5C8}"/>
                </a:ext>
              </a:extLst>
            </p:cNvPr>
            <p:cNvSpPr txBox="1"/>
            <p:nvPr/>
          </p:nvSpPr>
          <p:spPr>
            <a:xfrm>
              <a:off x="2642321" y="11119818"/>
              <a:ext cx="477550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YES</a:t>
              </a:r>
            </a:p>
          </p:txBody>
        </p:sp>
        <p:sp>
          <p:nvSpPr>
            <p:cNvPr id="101" name="Freeform 100">
              <a:extLst>
                <a:ext uri="{FF2B5EF4-FFF2-40B4-BE49-F238E27FC236}">
                  <a16:creationId xmlns:a16="http://schemas.microsoft.com/office/drawing/2014/main" id="{7ED0DEB6-5714-8DAA-41F0-030ECB11B0AA}"/>
                </a:ext>
              </a:extLst>
            </p:cNvPr>
            <p:cNvSpPr/>
            <p:nvPr/>
          </p:nvSpPr>
          <p:spPr>
            <a:xfrm>
              <a:off x="3429000" y="11068567"/>
              <a:ext cx="1105015" cy="292460"/>
            </a:xfrm>
            <a:custGeom>
              <a:avLst/>
              <a:gdLst>
                <a:gd name="connsiteX0" fmla="*/ 0 w 1105015"/>
                <a:gd name="connsiteY0" fmla="*/ 0 h 292460"/>
                <a:gd name="connsiteX1" fmla="*/ 0 w 1105015"/>
                <a:gd name="connsiteY1" fmla="*/ 184169 h 292460"/>
                <a:gd name="connsiteX2" fmla="*/ 1105015 w 1105015"/>
                <a:gd name="connsiteY2" fmla="*/ 184169 h 292460"/>
                <a:gd name="connsiteX3" fmla="*/ 1105015 w 1105015"/>
                <a:gd name="connsiteY3" fmla="*/ 292461 h 2924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05015" h="292460">
                  <a:moveTo>
                    <a:pt x="0" y="0"/>
                  </a:moveTo>
                  <a:lnTo>
                    <a:pt x="0" y="184169"/>
                  </a:lnTo>
                  <a:lnTo>
                    <a:pt x="1105015" y="184169"/>
                  </a:lnTo>
                  <a:lnTo>
                    <a:pt x="1105015" y="292461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2" name="Freeform 101">
              <a:extLst>
                <a:ext uri="{FF2B5EF4-FFF2-40B4-BE49-F238E27FC236}">
                  <a16:creationId xmlns:a16="http://schemas.microsoft.com/office/drawing/2014/main" id="{E8A454A3-7961-6120-E3A6-C610D56888AC}"/>
                </a:ext>
              </a:extLst>
            </p:cNvPr>
            <p:cNvSpPr/>
            <p:nvPr/>
          </p:nvSpPr>
          <p:spPr>
            <a:xfrm>
              <a:off x="4497181" y="11342611"/>
              <a:ext cx="73667" cy="73667"/>
            </a:xfrm>
            <a:custGeom>
              <a:avLst/>
              <a:gdLst>
                <a:gd name="connsiteX0" fmla="*/ 36834 w 73667"/>
                <a:gd name="connsiteY0" fmla="*/ 73668 h 73667"/>
                <a:gd name="connsiteX1" fmla="*/ 0 w 73667"/>
                <a:gd name="connsiteY1" fmla="*/ 0 h 73667"/>
                <a:gd name="connsiteX2" fmla="*/ 36834 w 73667"/>
                <a:gd name="connsiteY2" fmla="*/ 18417 h 73667"/>
                <a:gd name="connsiteX3" fmla="*/ 73668 w 73667"/>
                <a:gd name="connsiteY3" fmla="*/ 0 h 736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667" h="73667">
                  <a:moveTo>
                    <a:pt x="36834" y="73668"/>
                  </a:moveTo>
                  <a:lnTo>
                    <a:pt x="0" y="0"/>
                  </a:lnTo>
                  <a:lnTo>
                    <a:pt x="36834" y="18417"/>
                  </a:lnTo>
                  <a:lnTo>
                    <a:pt x="73668" y="0"/>
                  </a:lnTo>
                  <a:close/>
                </a:path>
              </a:pathLst>
            </a:custGeom>
            <a:solidFill>
              <a:srgbClr val="000000"/>
            </a:solidFill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776DA0CF-E1CD-75FD-B03E-0326BAC96FF7}"/>
                </a:ext>
              </a:extLst>
            </p:cNvPr>
            <p:cNvSpPr txBox="1"/>
            <p:nvPr/>
          </p:nvSpPr>
          <p:spPr>
            <a:xfrm>
              <a:off x="3774961" y="11119818"/>
              <a:ext cx="403883" cy="23877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NO</a:t>
              </a:r>
            </a:p>
          </p:txBody>
        </p:sp>
        <p:sp>
          <p:nvSpPr>
            <p:cNvPr id="104" name="Freeform 103">
              <a:extLst>
                <a:ext uri="{FF2B5EF4-FFF2-40B4-BE49-F238E27FC236}">
                  <a16:creationId xmlns:a16="http://schemas.microsoft.com/office/drawing/2014/main" id="{F253BE63-1F5D-9346-317B-759D61272F54}"/>
                </a:ext>
              </a:extLst>
            </p:cNvPr>
            <p:cNvSpPr/>
            <p:nvPr/>
          </p:nvSpPr>
          <p:spPr>
            <a:xfrm>
              <a:off x="1403138" y="10700229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5" name="Freeform 104">
              <a:extLst>
                <a:ext uri="{FF2B5EF4-FFF2-40B4-BE49-F238E27FC236}">
                  <a16:creationId xmlns:a16="http://schemas.microsoft.com/office/drawing/2014/main" id="{248F7DB2-A34C-F62B-113C-F6E676AF1991}"/>
                </a:ext>
              </a:extLst>
            </p:cNvPr>
            <p:cNvSpPr/>
            <p:nvPr/>
          </p:nvSpPr>
          <p:spPr>
            <a:xfrm>
              <a:off x="1403138" y="10700229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lnTo>
                    <a:pt x="4051722" y="368338"/>
                  </a:lnTo>
                  <a:lnTo>
                    <a:pt x="0" y="368338"/>
                  </a:lnTo>
                  <a:close/>
                </a:path>
              </a:pathLst>
            </a:custGeom>
            <a:noFill/>
            <a:ln w="9203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6" name="Freeform 105">
              <a:extLst>
                <a:ext uri="{FF2B5EF4-FFF2-40B4-BE49-F238E27FC236}">
                  <a16:creationId xmlns:a16="http://schemas.microsoft.com/office/drawing/2014/main" id="{B15A82EC-EB3B-6B92-2E26-FF7026B2C83B}"/>
                </a:ext>
              </a:extLst>
            </p:cNvPr>
            <p:cNvSpPr/>
            <p:nvPr/>
          </p:nvSpPr>
          <p:spPr>
            <a:xfrm>
              <a:off x="1403138" y="10700229"/>
              <a:ext cx="4051722" cy="368338"/>
            </a:xfrm>
            <a:custGeom>
              <a:avLst/>
              <a:gdLst>
                <a:gd name="connsiteX0" fmla="*/ 0 w 4051722"/>
                <a:gd name="connsiteY0" fmla="*/ 0 h 368338"/>
                <a:gd name="connsiteX1" fmla="*/ 4051722 w 4051722"/>
                <a:gd name="connsiteY1" fmla="*/ 0 h 368338"/>
                <a:gd name="connsiteX2" fmla="*/ 4051722 w 4051722"/>
                <a:gd name="connsiteY2" fmla="*/ 368338 h 368338"/>
                <a:gd name="connsiteX3" fmla="*/ 0 w 4051722"/>
                <a:gd name="connsiteY3" fmla="*/ 368338 h 3683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51722" h="368338">
                  <a:moveTo>
                    <a:pt x="0" y="0"/>
                  </a:moveTo>
                  <a:lnTo>
                    <a:pt x="4051722" y="0"/>
                  </a:lnTo>
                  <a:moveTo>
                    <a:pt x="4051722" y="368338"/>
                  </a:moveTo>
                  <a:lnTo>
                    <a:pt x="0" y="368338"/>
                  </a:lnTo>
                </a:path>
              </a:pathLst>
            </a:custGeom>
            <a:noFill/>
            <a:ln w="18406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6FF7DF27-5122-56CE-68B8-178DACDC4BBE}"/>
                </a:ext>
              </a:extLst>
            </p:cNvPr>
            <p:cNvSpPr txBox="1"/>
            <p:nvPr/>
          </p:nvSpPr>
          <p:spPr>
            <a:xfrm>
              <a:off x="1561827" y="10731437"/>
              <a:ext cx="3772536" cy="2855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Excluded for missing ethnicity and/or smoking status da</a:t>
              </a:r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ta</a:t>
              </a:r>
              <a:endParaRPr lang="en-US" sz="1160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108" name="Freeform 107">
              <a:extLst>
                <a:ext uri="{FF2B5EF4-FFF2-40B4-BE49-F238E27FC236}">
                  <a16:creationId xmlns:a16="http://schemas.microsoft.com/office/drawing/2014/main" id="{E7A37EC5-7B7C-CC2C-CDB6-65018D996D9C}"/>
                </a:ext>
              </a:extLst>
            </p:cNvPr>
            <p:cNvSpPr/>
            <p:nvPr/>
          </p:nvSpPr>
          <p:spPr>
            <a:xfrm>
              <a:off x="3613169" y="11436906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FFFFF"/>
            </a:solidFill>
            <a:ln w="36813" cap="flat">
              <a:solidFill>
                <a:srgbClr val="00000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53CE53D0-D9E2-27C6-0F3D-D752988A0051}"/>
                </a:ext>
              </a:extLst>
            </p:cNvPr>
            <p:cNvSpPr txBox="1"/>
            <p:nvPr/>
          </p:nvSpPr>
          <p:spPr>
            <a:xfrm>
              <a:off x="4049357" y="11474273"/>
              <a:ext cx="987729" cy="661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INCLUDE</a:t>
              </a:r>
            </a:p>
            <a:p>
              <a:pPr algn="ctr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&lt;34w, n=65</a:t>
              </a:r>
            </a:p>
            <a:p>
              <a:pPr algn="ctr"/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≥37w, n=266</a:t>
              </a:r>
              <a:endParaRPr lang="en-US" sz="1160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endParaRPr>
            </a:p>
          </p:txBody>
        </p:sp>
        <p:sp>
          <p:nvSpPr>
            <p:cNvPr id="110" name="Freeform 109">
              <a:extLst>
                <a:ext uri="{FF2B5EF4-FFF2-40B4-BE49-F238E27FC236}">
                  <a16:creationId xmlns:a16="http://schemas.microsoft.com/office/drawing/2014/main" id="{D4DC35D3-6D68-85E3-8620-AA07332BED10}"/>
                </a:ext>
              </a:extLst>
            </p:cNvPr>
            <p:cNvSpPr/>
            <p:nvPr/>
          </p:nvSpPr>
          <p:spPr>
            <a:xfrm>
              <a:off x="1403138" y="11436906"/>
              <a:ext cx="1841691" cy="736676"/>
            </a:xfrm>
            <a:custGeom>
              <a:avLst/>
              <a:gdLst>
                <a:gd name="connsiteX0" fmla="*/ 0 w 1841691"/>
                <a:gd name="connsiteY0" fmla="*/ 0 h 736676"/>
                <a:gd name="connsiteX1" fmla="*/ 1841692 w 1841691"/>
                <a:gd name="connsiteY1" fmla="*/ 0 h 736676"/>
                <a:gd name="connsiteX2" fmla="*/ 1841692 w 1841691"/>
                <a:gd name="connsiteY2" fmla="*/ 736677 h 736676"/>
                <a:gd name="connsiteX3" fmla="*/ 0 w 1841691"/>
                <a:gd name="connsiteY3" fmla="*/ 736677 h 7366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841691" h="736676">
                  <a:moveTo>
                    <a:pt x="0" y="0"/>
                  </a:moveTo>
                  <a:lnTo>
                    <a:pt x="1841692" y="0"/>
                  </a:lnTo>
                  <a:lnTo>
                    <a:pt x="1841692" y="736677"/>
                  </a:lnTo>
                  <a:lnTo>
                    <a:pt x="0" y="736677"/>
                  </a:lnTo>
                  <a:close/>
                </a:path>
              </a:pathLst>
            </a:custGeom>
            <a:solidFill>
              <a:srgbClr val="F5F5F5"/>
            </a:solidFill>
            <a:ln w="18406" cap="flat">
              <a:solidFill>
                <a:srgbClr val="666666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en-US"/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918A63A7-E1DF-6CE0-26DC-C7ED9E405F44}"/>
                </a:ext>
              </a:extLst>
            </p:cNvPr>
            <p:cNvSpPr txBox="1"/>
            <p:nvPr/>
          </p:nvSpPr>
          <p:spPr>
            <a:xfrm>
              <a:off x="1852953" y="11497577"/>
              <a:ext cx="915650" cy="6619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60" b="1" spc="0" baseline="0" dirty="0">
                  <a:solidFill>
                    <a:srgbClr val="333333"/>
                  </a:solidFill>
                  <a:latin typeface="Helvetica"/>
                  <a:sym typeface="Helvetica"/>
                  <a:rtl val="0"/>
                </a:rPr>
                <a:t>EXCLUDE</a:t>
              </a:r>
            </a:p>
            <a:p>
              <a:pPr algn="ctr"/>
              <a:r>
                <a:rPr lang="en-US" sz="1160" spc="0" baseline="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&lt;34w, n=5</a:t>
              </a:r>
            </a:p>
            <a:p>
              <a:pPr algn="ctr"/>
              <a:r>
                <a:rPr lang="en-US" sz="1160" dirty="0">
                  <a:solidFill>
                    <a:srgbClr val="000000"/>
                  </a:solidFill>
                  <a:latin typeface="Helvetica"/>
                  <a:sym typeface="Helvetica"/>
                  <a:rtl val="0"/>
                </a:rPr>
                <a:t>≥37w, n=26</a:t>
              </a:r>
              <a:endParaRPr lang="en-US" sz="1160" spc="0" baseline="0" dirty="0">
                <a:solidFill>
                  <a:srgbClr val="333333"/>
                </a:solidFill>
                <a:latin typeface="Helvetica"/>
                <a:sym typeface="Helvetica"/>
                <a:rtl val="0"/>
              </a:endParaRPr>
            </a:p>
          </p:txBody>
        </p: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DC5C337E-1571-687D-2271-F4E10EB6AA2E}"/>
              </a:ext>
            </a:extLst>
          </p:cNvPr>
          <p:cNvSpPr txBox="1"/>
          <p:nvPr/>
        </p:nvSpPr>
        <p:spPr>
          <a:xfrm>
            <a:off x="3774072" y="9229782"/>
            <a:ext cx="1875835" cy="11633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60" b="1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rPr>
              <a:t>MISSING DATA</a:t>
            </a:r>
          </a:p>
          <a:p>
            <a:pPr algn="ctr"/>
            <a:r>
              <a:rPr lang="en-US" sz="1160" dirty="0">
                <a:solidFill>
                  <a:srgbClr val="000000"/>
                </a:solidFill>
                <a:latin typeface="Helvetica"/>
                <a:sym typeface="Helvetica"/>
                <a:rtl val="0"/>
              </a:rPr>
              <a:t>BMI, </a:t>
            </a:r>
            <a:r>
              <a:rPr lang="en-US" sz="1160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rPr>
              <a:t>n=50</a:t>
            </a:r>
          </a:p>
          <a:p>
            <a:pPr algn="ctr"/>
            <a:r>
              <a:rPr lang="en-US" sz="1160" dirty="0">
                <a:solidFill>
                  <a:srgbClr val="000000"/>
                </a:solidFill>
                <a:latin typeface="Helvetica"/>
                <a:sym typeface="Helvetica"/>
                <a:rtl val="0"/>
              </a:rPr>
              <a:t>Age, n=3</a:t>
            </a:r>
            <a:endParaRPr lang="en-US" sz="1160" spc="0" baseline="0" dirty="0">
              <a:solidFill>
                <a:srgbClr val="000000"/>
              </a:solidFill>
              <a:latin typeface="Helvetica"/>
              <a:sym typeface="Helvetica"/>
              <a:rtl val="0"/>
            </a:endParaRPr>
          </a:p>
          <a:p>
            <a:pPr algn="ctr"/>
            <a:r>
              <a:rPr lang="en-US" sz="1160" dirty="0">
                <a:solidFill>
                  <a:srgbClr val="000000"/>
                </a:solidFill>
                <a:latin typeface="Helvetica"/>
                <a:sym typeface="Helvetica"/>
                <a:rtl val="0"/>
              </a:rPr>
              <a:t>Ethnicity (Simplified), n=7</a:t>
            </a:r>
          </a:p>
          <a:p>
            <a:pPr algn="ctr"/>
            <a:r>
              <a:rPr lang="en-US" sz="1160" spc="0" baseline="0" dirty="0">
                <a:solidFill>
                  <a:srgbClr val="000000"/>
                </a:solidFill>
                <a:latin typeface="Helvetica"/>
                <a:sym typeface="Helvetica"/>
                <a:rtl val="0"/>
              </a:rPr>
              <a:t>Smoking Status, n=</a:t>
            </a:r>
            <a:r>
              <a:rPr lang="en-US" sz="1160" dirty="0">
                <a:solidFill>
                  <a:srgbClr val="000000"/>
                </a:solidFill>
                <a:latin typeface="Helvetica"/>
                <a:sym typeface="Helvetica"/>
                <a:rtl val="0"/>
              </a:rPr>
              <a:t>19</a:t>
            </a:r>
            <a:endParaRPr lang="en-US" sz="1160" spc="0" baseline="0" dirty="0">
              <a:solidFill>
                <a:srgbClr val="000000"/>
              </a:solidFill>
              <a:latin typeface="Helvetica"/>
              <a:sym typeface="Helvetica"/>
              <a:rtl val="0"/>
            </a:endParaRPr>
          </a:p>
          <a:p>
            <a:pPr algn="ctr"/>
            <a:endParaRPr lang="en-US" sz="1160" spc="0" baseline="0" dirty="0">
              <a:solidFill>
                <a:srgbClr val="000000"/>
              </a:solidFill>
              <a:latin typeface="Helvetica"/>
              <a:sym typeface="Helvetica"/>
              <a:rtl val="0"/>
            </a:endParaRPr>
          </a:p>
        </p:txBody>
      </p:sp>
    </p:spTree>
    <p:extLst>
      <p:ext uri="{BB962C8B-B14F-4D97-AF65-F5344CB8AC3E}">
        <p14:creationId xmlns:p14="http://schemas.microsoft.com/office/powerpoint/2010/main" val="2743580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2C6558F88BE734894A08D8394EE58EE" ma:contentTypeVersion="13" ma:contentTypeDescription="Create a new document." ma:contentTypeScope="" ma:versionID="58c1488a1f6ef45be0f0e35dd2996602">
  <xsd:schema xmlns:xsd="http://www.w3.org/2001/XMLSchema" xmlns:xs="http://www.w3.org/2001/XMLSchema" xmlns:p="http://schemas.microsoft.com/office/2006/metadata/properties" xmlns:ns2="b698f96d-d5ec-48b2-ae82-8afd58f7cf55" xmlns:ns3="32d959d4-bd39-4a03-8053-226e0a73a35d" targetNamespace="http://schemas.microsoft.com/office/2006/metadata/properties" ma:root="true" ma:fieldsID="4d71ccab07e3c74066be0ea2b6571848" ns2:_="" ns3:_="">
    <xsd:import namespace="b698f96d-d5ec-48b2-ae82-8afd58f7cf55"/>
    <xsd:import namespace="32d959d4-bd39-4a03-8053-226e0a73a35d"/>
    <xsd:element name="properties">
      <xsd:complexType>
        <xsd:sequence>
          <xsd:element name="documentManagement">
            <xsd:complexType>
              <xsd:all>
                <xsd:element ref="ns2:lcf76f155ced4ddcb4097134ff3c332f" minOccurs="0"/>
                <xsd:element ref="ns3:TaxCatchAll" minOccurs="0"/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DateTaken" minOccurs="0"/>
                <xsd:element ref="ns2:MediaServiceObjectDetectorVersions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MediaServiceOCR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698f96d-d5ec-48b2-ae82-8afd58f7cf55" elementFormDefault="qualified">
    <xsd:import namespace="http://schemas.microsoft.com/office/2006/documentManagement/types"/>
    <xsd:import namespace="http://schemas.microsoft.com/office/infopath/2007/PartnerControls"/>
    <xsd:element name="lcf76f155ced4ddcb4097134ff3c332f" ma:index="9" nillable="true" ma:taxonomy="true" ma:internalName="lcf76f155ced4ddcb4097134ff3c332f" ma:taxonomyFieldName="MediaServiceImageTags" ma:displayName="Image Tags" ma:readOnly="false" ma:fieldId="{5cf76f15-5ced-4ddc-b409-7134ff3c332f}" ma:taxonomyMulti="true" ma:sspId="947fb5a4-a0ac-49d0-9a4e-8590e20716b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d959d4-bd39-4a03-8053-226e0a73a35d" elementFormDefault="qualified">
    <xsd:import namespace="http://schemas.microsoft.com/office/2006/documentManagement/types"/>
    <xsd:import namespace="http://schemas.microsoft.com/office/infopath/2007/PartnerControls"/>
    <xsd:element name="TaxCatchAll" ma:index="10" nillable="true" ma:displayName="Taxonomy Catch All Column" ma:hidden="true" ma:list="{13d8c34a-7f38-44f5-a8e7-c781c9b378c9}" ma:internalName="TaxCatchAll" ma:showField="CatchAllData" ma:web="32d959d4-bd39-4a03-8053-226e0a73a35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32d959d4-bd39-4a03-8053-226e0a73a35d" xsi:nil="true"/>
    <lcf76f155ced4ddcb4097134ff3c332f xmlns="b698f96d-d5ec-48b2-ae82-8afd58f7cf55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CF194FBC-62A5-446F-A63B-A454476672E6}"/>
</file>

<file path=customXml/itemProps2.xml><?xml version="1.0" encoding="utf-8"?>
<ds:datastoreItem xmlns:ds="http://schemas.openxmlformats.org/officeDocument/2006/customXml" ds:itemID="{8BE7FF15-DC2F-4EF7-BD9D-9D135FD79793}"/>
</file>

<file path=customXml/itemProps3.xml><?xml version="1.0" encoding="utf-8"?>
<ds:datastoreItem xmlns:ds="http://schemas.openxmlformats.org/officeDocument/2006/customXml" ds:itemID="{FA79AFE6-C2C8-47DE-A6EC-F81E68B55130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178</Words>
  <Application>Microsoft Macintosh PowerPoint</Application>
  <PresentationFormat>Widescreen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, Sherrianne Q Y</dc:creator>
  <cp:lastModifiedBy>Ng, Sherrianne Q Y</cp:lastModifiedBy>
  <cp:revision>4</cp:revision>
  <dcterms:created xsi:type="dcterms:W3CDTF">2025-01-27T17:43:50Z</dcterms:created>
  <dcterms:modified xsi:type="dcterms:W3CDTF">2025-01-28T09:11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2C6558F88BE734894A08D8394EE58EE</vt:lpwstr>
  </property>
</Properties>
</file>